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66" r:id="rId2"/>
    <p:sldId id="271" r:id="rId3"/>
    <p:sldId id="259" r:id="rId4"/>
    <p:sldId id="260" r:id="rId5"/>
    <p:sldId id="261" r:id="rId6"/>
    <p:sldId id="262" r:id="rId7"/>
    <p:sldId id="273" r:id="rId8"/>
    <p:sldId id="270" r:id="rId9"/>
    <p:sldId id="263" r:id="rId10"/>
    <p:sldId id="264" r:id="rId11"/>
    <p:sldId id="265" r:id="rId1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56" autoAdjust="0"/>
    <p:restoredTop sz="94660"/>
  </p:normalViewPr>
  <p:slideViewPr>
    <p:cSldViewPr snapToGrid="0">
      <p:cViewPr varScale="1">
        <p:scale>
          <a:sx n="80" d="100"/>
          <a:sy n="80" d="100"/>
        </p:scale>
        <p:origin x="-34" y="35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0" d="100"/>
        <a:sy n="140" d="100"/>
      </p:scale>
      <p:origin x="0" y="-310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53B29E-49B8-4BA2-ACC2-C9C066E65AE9}" type="datetimeFigureOut">
              <a:rPr kumimoji="1" lang="ja-JP" altLang="en-US" smtClean="0"/>
              <a:t>2021/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0D1FD3-D161-485C-AA08-4D1DD5EBFC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21144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48DDD58-C762-43D7-800D-5D3EEA072B71}" type="slidenum">
              <a:rPr kumimoji="1" lang="ja-JP" altLang="en-US" smtClean="0"/>
              <a:pPr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290349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46F37E-1660-453C-B370-2BBA020F670C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84645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658C9-6F23-457E-8111-2E340F01171A}" type="datetimeFigureOut">
              <a:rPr kumimoji="1" lang="ja-JP" altLang="en-US" smtClean="0"/>
              <a:t>2021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C06EB-10F9-4B82-8AE3-C725D0EF09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532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658C9-6F23-457E-8111-2E340F01171A}" type="datetimeFigureOut">
              <a:rPr kumimoji="1" lang="ja-JP" altLang="en-US" smtClean="0"/>
              <a:t>2021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C06EB-10F9-4B82-8AE3-C725D0EF09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4307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658C9-6F23-457E-8111-2E340F01171A}" type="datetimeFigureOut">
              <a:rPr kumimoji="1" lang="ja-JP" altLang="en-US" smtClean="0"/>
              <a:t>2021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C06EB-10F9-4B82-8AE3-C725D0EF09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1589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658C9-6F23-457E-8111-2E340F01171A}" type="datetimeFigureOut">
              <a:rPr kumimoji="1" lang="ja-JP" altLang="en-US" smtClean="0"/>
              <a:t>2021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C06EB-10F9-4B82-8AE3-C725D0EF09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9324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658C9-6F23-457E-8111-2E340F01171A}" type="datetimeFigureOut">
              <a:rPr kumimoji="1" lang="ja-JP" altLang="en-US" smtClean="0"/>
              <a:t>2021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C06EB-10F9-4B82-8AE3-C725D0EF09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14599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658C9-6F23-457E-8111-2E340F01171A}" type="datetimeFigureOut">
              <a:rPr kumimoji="1" lang="ja-JP" altLang="en-US" smtClean="0"/>
              <a:t>2021/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C06EB-10F9-4B82-8AE3-C725D0EF09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50602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658C9-6F23-457E-8111-2E340F01171A}" type="datetimeFigureOut">
              <a:rPr kumimoji="1" lang="ja-JP" altLang="en-US" smtClean="0"/>
              <a:t>2021/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C06EB-10F9-4B82-8AE3-C725D0EF09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0487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658C9-6F23-457E-8111-2E340F01171A}" type="datetimeFigureOut">
              <a:rPr kumimoji="1" lang="ja-JP" altLang="en-US" smtClean="0"/>
              <a:t>2021/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C06EB-10F9-4B82-8AE3-C725D0EF09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4156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658C9-6F23-457E-8111-2E340F01171A}" type="datetimeFigureOut">
              <a:rPr kumimoji="1" lang="ja-JP" altLang="en-US" smtClean="0"/>
              <a:t>2021/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C06EB-10F9-4B82-8AE3-C725D0EF09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23594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658C9-6F23-457E-8111-2E340F01171A}" type="datetimeFigureOut">
              <a:rPr kumimoji="1" lang="ja-JP" altLang="en-US" smtClean="0"/>
              <a:t>2021/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C06EB-10F9-4B82-8AE3-C725D0EF09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0634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658C9-6F23-457E-8111-2E340F01171A}" type="datetimeFigureOut">
              <a:rPr kumimoji="1" lang="ja-JP" altLang="en-US" smtClean="0"/>
              <a:t>2021/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C06EB-10F9-4B82-8AE3-C725D0EF09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3308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D658C9-6F23-457E-8111-2E340F01171A}" type="datetimeFigureOut">
              <a:rPr kumimoji="1" lang="ja-JP" altLang="en-US" smtClean="0"/>
              <a:t>2021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FC06EB-10F9-4B82-8AE3-C725D0EF09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81040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g"/><Relationship Id="rId3" Type="http://schemas.microsoft.com/office/2007/relationships/hdphoto" Target="../media/hdphoto2.wdp"/><Relationship Id="rId7" Type="http://schemas.openxmlformats.org/officeDocument/2006/relationships/image" Target="../media/image15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jpeg"/><Relationship Id="rId5" Type="http://schemas.openxmlformats.org/officeDocument/2006/relationships/image" Target="../media/image13.jpg"/><Relationship Id="rId4" Type="http://schemas.openxmlformats.org/officeDocument/2006/relationships/image" Target="../media/image12.jpg"/><Relationship Id="rId9" Type="http://schemas.openxmlformats.org/officeDocument/2006/relationships/image" Target="../media/image17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601648" y="247862"/>
            <a:ext cx="10842172" cy="60785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76176" tIns="45720" rIns="9144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Supplementary</a:t>
            </a:r>
            <a:r>
              <a:rPr kumimoji="0" lang="ja-JP" altLang="en-US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kumimoji="0" lang="en-US" altLang="ja-JP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material</a:t>
            </a:r>
            <a:r>
              <a:rPr kumimoji="0" lang="ja-JP" altLang="en-US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endParaRPr kumimoji="0" lang="en-US" altLang="ja-JP" b="1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b="1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Development of a rapid scabies immunodiagnostic assay based on transcriptomic analysis of </a:t>
            </a:r>
            <a:r>
              <a:rPr kumimoji="0" lang="en-US" altLang="ja-JP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Sarcoptes</a:t>
            </a:r>
            <a:r>
              <a:rPr kumimoji="0" lang="en-US" altLang="ja-JP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kumimoji="0" lang="en-US" altLang="ja-JP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scabiei</a:t>
            </a:r>
            <a:r>
              <a:rPr kumimoji="0" lang="en-US" altLang="ja-JP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kumimoji="0" lang="en-US" altLang="ja-JP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var. </a:t>
            </a:r>
            <a:r>
              <a:rPr kumimoji="0" lang="en-US" altLang="ja-JP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nyctereutis</a:t>
            </a:r>
            <a:r>
              <a:rPr kumimoji="0" lang="en-US" altLang="ja-JP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Teruo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Akuta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1,2*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Daisuke Minegishi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3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Nobuhide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Kido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4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Keitaro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Imaizumi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1,2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Shinji Nakaoka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5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Shin-Ichiro Tachibana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6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Kenji Hikosaka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7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Fumi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Hori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8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Masataka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Nakagawa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1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Chiaki Sakuma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1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Yuki Oouchi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1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Yu Nakajima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1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Sohei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Tanaka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4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Tomoko Omiya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4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Kouki Morikaku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4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ＭＳ ゴシック" panose="020B0609070205080204" pitchFamily="49" charset="-128"/>
                <a:cs typeface="Arial" panose="020B0604020202020204" pitchFamily="34" charset="0"/>
              </a:rPr>
              <a:t>,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Minori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Kawahara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4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Yoshifumi Tada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3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Hiroshi Tarui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8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Takafumi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Ueda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2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Takane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Kikuchi-Ueda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2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&amp;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Yasuo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Ono</a:t>
            </a: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2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1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Research Division, Kyokuto Pharmaceutical Industrial Co., Ltd., 3333-26, Aza-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Asayama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Kamitezuna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Takahagi-shi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Ibaraki, 318-0004, Japan </a:t>
            </a:r>
            <a:endParaRPr kumimoji="0" lang="en-US" altLang="ja-JP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2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Department of Microbiology and Immunology,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Teikyo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University School of Medicine, 2-11-1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Kaga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Itabashi-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ku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Tokyo 173-8605, Japan</a:t>
            </a:r>
            <a:endParaRPr kumimoji="0" lang="en-US" altLang="ja-JP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3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Research Institute of Bio-System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Arial" panose="020B0604020202020204" pitchFamily="34" charset="0"/>
              </a:rPr>
              <a:t> 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Informatics, Tohoku Chemical Co., Ltd.,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Arial" panose="020B0604020202020204" pitchFamily="34" charset="0"/>
              </a:rPr>
              <a:t> 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6-15-5,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Mitake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Morioka, Iwate 020-0122, Japan</a:t>
            </a:r>
            <a:endParaRPr kumimoji="0" lang="en-US" altLang="ja-JP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4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Kanazawa Zoological Gardens, 5-15-1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Kamariyahigashi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Kanazawa-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ku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Yokohama, Kanazawa 236-0042, Japan</a:t>
            </a:r>
            <a:endParaRPr kumimoji="0" lang="en-US" altLang="ja-JP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5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Faculty of Advanced Life Science, Hokkaido University, Kita 10, Nishi 8, Kita-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ku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Sapporo 060-0810, Japan</a:t>
            </a:r>
            <a:endParaRPr kumimoji="0" lang="en-US" altLang="ja-JP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6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ＭＳ 明朝" panose="02020609040205080304" pitchFamily="17" charset="-128"/>
                <a:cs typeface="Arial" panose="020B0604020202020204" pitchFamily="34" charset="0"/>
              </a:rPr>
              <a:t>Genome Information Research Center, Research Institute for Microbial Diseases, Osaka University, 3-1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ＭＳ 明朝" panose="02020609040205080304" pitchFamily="17" charset="-128"/>
                <a:cs typeface="Arial" panose="020B0604020202020204" pitchFamily="34" charset="0"/>
              </a:rPr>
              <a:t>Yamadaoka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ＭＳ 明朝" panose="02020609040205080304" pitchFamily="17" charset="-128"/>
                <a:cs typeface="Arial" panose="020B0604020202020204" pitchFamily="34" charset="0"/>
              </a:rPr>
              <a:t>, Suita, Osaka 565-0871, Japan</a:t>
            </a:r>
            <a:endParaRPr kumimoji="0" lang="en-US" altLang="ja-JP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7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Department of Infection and Host Defense, Graduate School of Medicine, Chiba University, 1-8-1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Inohana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Chuo-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ku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, Chiba 260-8670, Japan</a:t>
            </a:r>
            <a:endParaRPr kumimoji="0" lang="en-US" altLang="ja-JP" sz="1600" b="0" i="0" u="none" strike="noStrike" cap="none" normalizeH="0" baseline="30000" dirty="0" smtClean="0">
              <a:ln>
                <a:noFill/>
              </a:ln>
              <a:solidFill>
                <a:srgbClr val="000000"/>
              </a:solidFill>
              <a:effectLst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ea typeface="ＭＳ 明朝" panose="02020609040205080304" pitchFamily="17" charset="-128"/>
                <a:cs typeface="Arial" panose="020B0604020202020204" pitchFamily="34" charset="0"/>
              </a:rPr>
              <a:t>8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ＭＳ 明朝" panose="02020609040205080304" pitchFamily="17" charset="-128"/>
                <a:cs typeface="Arial" panose="020B0604020202020204" pitchFamily="34" charset="0"/>
              </a:rPr>
              <a:t>Division of Genomic Technologies, Center for Life Science Technologies, RIKEN Yokohama Institute, 1-7-22 </a:t>
            </a:r>
            <a:r>
              <a:rPr kumimoji="0" lang="en-US" altLang="ja-JP" sz="1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ＭＳ 明朝" panose="02020609040205080304" pitchFamily="17" charset="-128"/>
                <a:cs typeface="Arial" panose="020B0604020202020204" pitchFamily="34" charset="0"/>
              </a:rPr>
              <a:t>Suehiro-cho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ＭＳ 明朝" panose="02020609040205080304" pitchFamily="17" charset="-128"/>
                <a:cs typeface="Arial" panose="020B0604020202020204" pitchFamily="34" charset="0"/>
              </a:rPr>
              <a:t>, Yokohama 230-0045, Japan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6702795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703512" y="188641"/>
            <a:ext cx="8712968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400" b="1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Table 2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AU" altLang="ja-JP" sz="1400" b="1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otein and scaffold accession numbers of </a:t>
            </a:r>
            <a:r>
              <a:rPr lang="en-AU" altLang="ja-JP" sz="1400" b="1" i="1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. </a:t>
            </a:r>
            <a:r>
              <a:rPr lang="en-AU" altLang="ja-JP" sz="1400" b="1" i="1" kern="100" dirty="0" err="1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cabiei</a:t>
            </a:r>
            <a:r>
              <a:rPr lang="en-AU" altLang="ja-JP" sz="1400" b="1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AU" altLang="ja-JP" sz="1400" b="1" kern="100" dirty="0" err="1" smtClean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vitellogenin</a:t>
            </a:r>
            <a:r>
              <a:rPr lang="en-AU" altLang="ja-JP" sz="1400" b="1" kern="100" dirty="0" smtClean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like </a:t>
            </a:r>
            <a:r>
              <a:rPr lang="en-AU" altLang="ja-JP" sz="1400" b="1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otein </a:t>
            </a:r>
            <a:r>
              <a:rPr lang="en-AU" altLang="ja-JP" sz="1400" b="1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nd homologous HDM 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5" name="表 4"/>
          <p:cNvGraphicFramePr>
            <a:graphicFrameLocks noGrp="1"/>
          </p:cNvGraphicFramePr>
          <p:nvPr>
            <p:extLst/>
          </p:nvPr>
        </p:nvGraphicFramePr>
        <p:xfrm>
          <a:off x="1919537" y="1988840"/>
          <a:ext cx="8711357" cy="3657600"/>
        </p:xfrm>
        <a:graphic>
          <a:graphicData uri="http://schemas.openxmlformats.org/drawingml/2006/table">
            <a:tbl>
              <a:tblPr firstRow="1" firstCol="1" bandRow="1">
                <a:tableStyleId>{616DA210-FB5B-4158-B5E0-FEB733F419BA}</a:tableStyleId>
              </a:tblPr>
              <a:tblGrid>
                <a:gridCol w="2237780">
                  <a:extLst>
                    <a:ext uri="{9D8B030D-6E8A-4147-A177-3AD203B41FA5}">
                      <a16:colId xmlns:a16="http://schemas.microsoft.com/office/drawing/2014/main" val="4143385425"/>
                    </a:ext>
                  </a:extLst>
                </a:gridCol>
                <a:gridCol w="2317701">
                  <a:extLst>
                    <a:ext uri="{9D8B030D-6E8A-4147-A177-3AD203B41FA5}">
                      <a16:colId xmlns:a16="http://schemas.microsoft.com/office/drawing/2014/main" val="3359282225"/>
                    </a:ext>
                  </a:extLst>
                </a:gridCol>
                <a:gridCol w="1802290">
                  <a:extLst>
                    <a:ext uri="{9D8B030D-6E8A-4147-A177-3AD203B41FA5}">
                      <a16:colId xmlns:a16="http://schemas.microsoft.com/office/drawing/2014/main" val="3980444054"/>
                    </a:ext>
                  </a:extLst>
                </a:gridCol>
                <a:gridCol w="2353586">
                  <a:extLst>
                    <a:ext uri="{9D8B030D-6E8A-4147-A177-3AD203B41FA5}">
                      <a16:colId xmlns:a16="http://schemas.microsoft.com/office/drawing/2014/main" val="1516005879"/>
                    </a:ext>
                  </a:extLst>
                </a:gridCol>
              </a:tblGrid>
              <a:tr h="73152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AU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altLang="ja-JP" sz="1200" kern="1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tellogenin</a:t>
                      </a:r>
                      <a:r>
                        <a:rPr lang="ja-JP" altLang="en-US" sz="1200" kern="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kern="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molog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AU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ccoon dog mite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AU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AU" sz="1200" i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. </a:t>
                      </a:r>
                      <a:r>
                        <a:rPr lang="en-AU" sz="1200" i="1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abiei</a:t>
                      </a:r>
                      <a:r>
                        <a:rPr lang="en-AU" sz="1200" i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AU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. </a:t>
                      </a:r>
                      <a:r>
                        <a:rPr lang="en-AU" sz="1200" i="1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yctereutis</a:t>
                      </a:r>
                      <a:r>
                        <a:rPr lang="en-AU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AU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 mite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AU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AU" sz="1200" i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. </a:t>
                      </a:r>
                      <a:r>
                        <a:rPr lang="en-AU" sz="1200" i="1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abiei</a:t>
                      </a:r>
                      <a:r>
                        <a:rPr lang="en-AU" sz="1200" i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AU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. </a:t>
                      </a:r>
                      <a:r>
                        <a:rPr lang="en-AU" sz="1200" i="1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is</a:t>
                      </a:r>
                      <a:r>
                        <a:rPr lang="en-AU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AU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mite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AU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AU" sz="1200" i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. </a:t>
                      </a:r>
                      <a:r>
                        <a:rPr lang="en-AU" sz="1200" i="1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abiei</a:t>
                      </a:r>
                      <a:r>
                        <a:rPr lang="en-AU" sz="1200" i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AU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. </a:t>
                      </a:r>
                      <a:r>
                        <a:rPr lang="en-AU" sz="1200" i="1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minis</a:t>
                      </a:r>
                      <a:r>
                        <a:rPr lang="en-AU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/>
                </a:tc>
                <a:extLst>
                  <a:ext uri="{0D108BD9-81ED-4DB2-BD59-A6C34878D82A}">
                    <a16:rowId xmlns:a16="http://schemas.microsoft.com/office/drawing/2014/main" val="1859610457"/>
                  </a:ext>
                </a:extLst>
              </a:tr>
              <a:tr h="73152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AU" sz="1200" i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. </a:t>
                      </a:r>
                      <a:r>
                        <a:rPr lang="en-AU" sz="1200" i="1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abiei</a:t>
                      </a:r>
                      <a:endParaRPr lang="ja-JP" sz="1200" i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R="254000" algn="ctr">
                        <a:spcAft>
                          <a:spcPts val="0"/>
                        </a:spcAft>
                      </a:pPr>
                      <a:r>
                        <a:rPr lang="en-AU" sz="12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tellogenin</a:t>
                      </a:r>
                      <a:r>
                        <a:rPr lang="en-AU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like protein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ACW01000323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AU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M02263.1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A: scaffold41081_cov61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B: scaffold6362_cov109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12764496"/>
                  </a:ext>
                </a:extLst>
              </a:tr>
              <a:tr h="73152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AU" sz="1200" i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r. p </a:t>
                      </a:r>
                      <a:endParaRPr lang="ja-JP" sz="1200" i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R="254000" algn="ctr">
                        <a:spcAft>
                          <a:spcPts val="0"/>
                        </a:spcAft>
                      </a:pPr>
                      <a:r>
                        <a:rPr lang="en-AU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tellogenin-6-like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AU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P_027195573.1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/>
                      <a:endParaRPr lang="ja-JP" sz="120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/>
                      <a:endParaRPr lang="ja-JP" sz="120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865" marR="62865" marT="0" marB="0"/>
                </a:tc>
                <a:extLst>
                  <a:ext uri="{0D108BD9-81ED-4DB2-BD59-A6C34878D82A}">
                    <a16:rowId xmlns:a16="http://schemas.microsoft.com/office/drawing/2014/main" val="721810037"/>
                  </a:ext>
                </a:extLst>
              </a:tr>
              <a:tr h="73152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AU" sz="1200" i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r. f  </a:t>
                      </a:r>
                      <a:endParaRPr lang="ja-JP" sz="1200" i="1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R="254000" algn="ctr"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lipophorin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AU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BD75204.1</a:t>
                      </a:r>
                      <a:endParaRPr lang="ja-JP" sz="12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/>
                      <a:endParaRPr lang="ja-JP" sz="120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l"/>
                      <a:endParaRPr lang="ja-JP" sz="120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865" marR="62865" marT="0" marB="0"/>
                </a:tc>
                <a:extLst>
                  <a:ext uri="{0D108BD9-81ED-4DB2-BD59-A6C34878D82A}">
                    <a16:rowId xmlns:a16="http://schemas.microsoft.com/office/drawing/2014/main" val="1382999720"/>
                  </a:ext>
                </a:extLst>
              </a:tr>
              <a:tr h="73152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AU" sz="1200" i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r. f  </a:t>
                      </a:r>
                      <a:endParaRPr lang="ja-JP" sz="1200" i="1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dicted </a:t>
                      </a:r>
                      <a:r>
                        <a:rPr lang="en-US" sz="12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tellogenin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521: scaffold90_size237115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ja-JP" sz="12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/>
                </a:tc>
                <a:extLst>
                  <a:ext uri="{0D108BD9-81ED-4DB2-BD59-A6C34878D82A}">
                    <a16:rowId xmlns:a16="http://schemas.microsoft.com/office/drawing/2014/main" val="54467252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361846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/>
          </p:nvPr>
        </p:nvGraphicFramePr>
        <p:xfrm>
          <a:off x="2063554" y="1412776"/>
          <a:ext cx="8384459" cy="4969862"/>
        </p:xfrm>
        <a:graphic>
          <a:graphicData uri="http://schemas.openxmlformats.org/drawingml/2006/table">
            <a:tbl>
              <a:tblPr firstRow="1" firstCol="1" bandRow="1">
                <a:tableStyleId>{616DA210-FB5B-4158-B5E0-FEB733F419BA}</a:tableStyleId>
              </a:tblPr>
              <a:tblGrid>
                <a:gridCol w="1441444">
                  <a:extLst>
                    <a:ext uri="{9D8B030D-6E8A-4147-A177-3AD203B41FA5}">
                      <a16:colId xmlns:a16="http://schemas.microsoft.com/office/drawing/2014/main" val="3801677032"/>
                    </a:ext>
                  </a:extLst>
                </a:gridCol>
                <a:gridCol w="3245659">
                  <a:extLst>
                    <a:ext uri="{9D8B030D-6E8A-4147-A177-3AD203B41FA5}">
                      <a16:colId xmlns:a16="http://schemas.microsoft.com/office/drawing/2014/main" val="1114423630"/>
                    </a:ext>
                  </a:extLst>
                </a:gridCol>
                <a:gridCol w="1903151">
                  <a:extLst>
                    <a:ext uri="{9D8B030D-6E8A-4147-A177-3AD203B41FA5}">
                      <a16:colId xmlns:a16="http://schemas.microsoft.com/office/drawing/2014/main" val="2048331990"/>
                    </a:ext>
                  </a:extLst>
                </a:gridCol>
                <a:gridCol w="1794205">
                  <a:extLst>
                    <a:ext uri="{9D8B030D-6E8A-4147-A177-3AD203B41FA5}">
                      <a16:colId xmlns:a16="http://schemas.microsoft.com/office/drawing/2014/main" val="3482254643"/>
                    </a:ext>
                  </a:extLst>
                </a:gridCol>
              </a:tblGrid>
              <a:tr h="6427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kern="100" dirty="0" smtClean="0">
                          <a:effectLst/>
                          <a:latin typeface="Century" panose="020406040505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Ranking</a:t>
                      </a:r>
                      <a:r>
                        <a:rPr lang="ja-JP" altLang="en-US" sz="1200" kern="100" dirty="0" smtClean="0">
                          <a:effectLst/>
                          <a:latin typeface="Century" panose="020406040505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</a:t>
                      </a:r>
                      <a:endParaRPr lang="en-US" altLang="ja-JP" sz="1200" kern="100" dirty="0" smtClean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kern="100" dirty="0" smtClean="0">
                          <a:effectLst/>
                          <a:latin typeface="Century" panose="020406040505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(based</a:t>
                      </a:r>
                      <a:r>
                        <a:rPr lang="ja-JP" altLang="en-US" sz="1200" kern="100" dirty="0" smtClean="0">
                          <a:effectLst/>
                          <a:latin typeface="Century" panose="020406040505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kern="100" dirty="0" smtClean="0">
                          <a:effectLst/>
                          <a:latin typeface="Century" panose="020406040505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on</a:t>
                      </a:r>
                      <a:r>
                        <a:rPr lang="ja-JP" altLang="en-US" sz="1200" kern="100" dirty="0" smtClean="0">
                          <a:effectLst/>
                          <a:latin typeface="Century" panose="020406040505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kern="100" dirty="0" smtClean="0">
                          <a:effectLst/>
                          <a:latin typeface="Century" panose="020406040505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gene</a:t>
                      </a:r>
                      <a:r>
                        <a:rPr lang="ja-JP" altLang="en-US" sz="1200" kern="100" dirty="0" smtClean="0">
                          <a:effectLst/>
                          <a:latin typeface="Century" panose="020406040505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kern="100" dirty="0" smtClean="0">
                          <a:effectLst/>
                          <a:latin typeface="Century" panose="020406040505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expression)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Raccoon dog mite</a:t>
                      </a:r>
                      <a:br>
                        <a:rPr lang="en-US" sz="1200" kern="0" dirty="0">
                          <a:effectLst/>
                        </a:rPr>
                      </a:br>
                      <a:r>
                        <a:rPr lang="en-US" sz="1200" kern="0" dirty="0">
                          <a:effectLst/>
                        </a:rPr>
                        <a:t>(</a:t>
                      </a:r>
                      <a:r>
                        <a:rPr lang="en-US" sz="1200" i="1" kern="0" dirty="0">
                          <a:effectLst/>
                        </a:rPr>
                        <a:t>S. </a:t>
                      </a:r>
                      <a:r>
                        <a:rPr lang="en-US" sz="1200" i="1" kern="0" dirty="0" err="1">
                          <a:effectLst/>
                        </a:rPr>
                        <a:t>scabiei</a:t>
                      </a:r>
                      <a:r>
                        <a:rPr lang="en-US" sz="1200" i="1" kern="0" dirty="0">
                          <a:effectLst/>
                        </a:rPr>
                        <a:t> </a:t>
                      </a:r>
                      <a:r>
                        <a:rPr lang="en-US" sz="1200" kern="0" dirty="0">
                          <a:effectLst/>
                        </a:rPr>
                        <a:t>var. </a:t>
                      </a:r>
                      <a:r>
                        <a:rPr lang="en-US" sz="1200" i="1" kern="0" dirty="0" err="1">
                          <a:effectLst/>
                        </a:rPr>
                        <a:t>canis</a:t>
                      </a:r>
                      <a:r>
                        <a:rPr lang="en-US" sz="1200" kern="0" dirty="0">
                          <a:effectLst/>
                        </a:rPr>
                        <a:t>)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Human mite</a:t>
                      </a:r>
                      <a:br>
                        <a:rPr lang="en-US" sz="1200" kern="0" dirty="0">
                          <a:effectLst/>
                        </a:rPr>
                      </a:br>
                      <a:r>
                        <a:rPr lang="en-US" sz="1200" kern="0" dirty="0">
                          <a:effectLst/>
                        </a:rPr>
                        <a:t>(</a:t>
                      </a:r>
                      <a:r>
                        <a:rPr lang="en-US" sz="1200" i="1" kern="0" dirty="0">
                          <a:effectLst/>
                        </a:rPr>
                        <a:t>S. </a:t>
                      </a:r>
                      <a:r>
                        <a:rPr lang="en-US" sz="1200" i="1" kern="0" dirty="0" err="1">
                          <a:effectLst/>
                        </a:rPr>
                        <a:t>scabiei</a:t>
                      </a:r>
                      <a:r>
                        <a:rPr lang="en-US" sz="1200" i="1" kern="0" dirty="0">
                          <a:effectLst/>
                        </a:rPr>
                        <a:t> </a:t>
                      </a:r>
                      <a:r>
                        <a:rPr lang="en-US" sz="1200" kern="0" dirty="0">
                          <a:effectLst/>
                        </a:rPr>
                        <a:t>var. </a:t>
                      </a:r>
                      <a:r>
                        <a:rPr lang="en-US" sz="1200" i="1" kern="0" dirty="0" err="1">
                          <a:effectLst/>
                        </a:rPr>
                        <a:t>hominis</a:t>
                      </a:r>
                      <a:r>
                        <a:rPr lang="en-US" sz="1200" kern="0" dirty="0">
                          <a:effectLst/>
                        </a:rPr>
                        <a:t>)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Dog mite</a:t>
                      </a:r>
                      <a:br>
                        <a:rPr lang="en-US" sz="1200" kern="0" dirty="0">
                          <a:effectLst/>
                        </a:rPr>
                      </a:br>
                      <a:r>
                        <a:rPr lang="en-US" sz="1200" kern="0" dirty="0">
                          <a:effectLst/>
                        </a:rPr>
                        <a:t>(</a:t>
                      </a:r>
                      <a:r>
                        <a:rPr lang="en-US" sz="1200" i="1" kern="0" dirty="0">
                          <a:effectLst/>
                        </a:rPr>
                        <a:t>S. </a:t>
                      </a:r>
                      <a:r>
                        <a:rPr lang="en-US" sz="1200" i="1" kern="0" dirty="0" err="1">
                          <a:effectLst/>
                        </a:rPr>
                        <a:t>scabiei</a:t>
                      </a:r>
                      <a:r>
                        <a:rPr lang="en-US" sz="1200" i="1" kern="0" dirty="0">
                          <a:effectLst/>
                        </a:rPr>
                        <a:t> </a:t>
                      </a:r>
                      <a:r>
                        <a:rPr lang="en-US" sz="1200" kern="0" dirty="0">
                          <a:effectLst/>
                        </a:rPr>
                        <a:t>var. </a:t>
                      </a:r>
                      <a:r>
                        <a:rPr lang="en-US" sz="1200" i="1" kern="0" dirty="0" err="1">
                          <a:effectLst/>
                        </a:rPr>
                        <a:t>canis</a:t>
                      </a:r>
                      <a:r>
                        <a:rPr lang="en-US" sz="1200" kern="0" dirty="0">
                          <a:effectLst/>
                        </a:rPr>
                        <a:t>)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extLst>
                  <a:ext uri="{0D108BD9-81ED-4DB2-BD59-A6C34878D82A}">
                    <a16:rowId xmlns:a16="http://schemas.microsoft.com/office/drawing/2014/main" val="2066795622"/>
                  </a:ext>
                </a:extLst>
              </a:tr>
              <a:tr h="32137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104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chemeClr val="tx1"/>
                          </a:solidFill>
                          <a:effectLst/>
                        </a:rPr>
                        <a:t>Sar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. S 1 cysteine protease–like protein 9</a:t>
                      </a:r>
                      <a:b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</a:b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(IACW01021976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AAS93675.1</a:t>
                      </a:r>
                      <a:br>
                        <a:rPr lang="en-US" sz="1200" kern="0" dirty="0">
                          <a:effectLst/>
                        </a:rPr>
                      </a:br>
                      <a:r>
                        <a:rPr lang="en-US" sz="1200" kern="0" dirty="0">
                          <a:effectLst/>
                        </a:rPr>
                        <a:t>SMIPP-Cc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KPM06027.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extLst>
                  <a:ext uri="{0D108BD9-81ED-4DB2-BD59-A6C34878D82A}">
                    <a16:rowId xmlns:a16="http://schemas.microsoft.com/office/drawing/2014/main" val="2175862922"/>
                  </a:ext>
                </a:extLst>
              </a:tr>
              <a:tr h="32137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173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chemeClr val="tx1"/>
                          </a:solidFill>
                          <a:effectLst/>
                        </a:rPr>
                        <a:t>Sar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. S 1 cysteine protease–like protein 3</a:t>
                      </a:r>
                      <a:b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</a:b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(IACW01001383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AAS93670.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KPM05041.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extLst>
                  <a:ext uri="{0D108BD9-81ED-4DB2-BD59-A6C34878D82A}">
                    <a16:rowId xmlns:a16="http://schemas.microsoft.com/office/drawing/2014/main" val="162912099"/>
                  </a:ext>
                </a:extLst>
              </a:tr>
              <a:tr h="32137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202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chemeClr val="tx1"/>
                          </a:solidFill>
                          <a:effectLst/>
                        </a:rPr>
                        <a:t>Sar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. S 1 cysteine protease–like protein 4</a:t>
                      </a:r>
                      <a:b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</a:b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(IACW01025771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</a:rPr>
                        <a:t>AAS93669.1</a:t>
                      </a:r>
                      <a:endParaRPr lang="ja-JP" sz="12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KPM05042.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extLst>
                  <a:ext uri="{0D108BD9-81ED-4DB2-BD59-A6C34878D82A}">
                    <a16:rowId xmlns:a16="http://schemas.microsoft.com/office/drawing/2014/main" val="2569558"/>
                  </a:ext>
                </a:extLst>
              </a:tr>
              <a:tr h="32137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563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chemeClr val="tx1"/>
                          </a:solidFill>
                          <a:effectLst/>
                        </a:rPr>
                        <a:t>Sar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. S 1 cysteine protease–like protein 10</a:t>
                      </a:r>
                      <a:b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</a:b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(IACW01021977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AAS93673.1</a:t>
                      </a:r>
                      <a:br>
                        <a:rPr lang="en-US" sz="1200" kern="0" dirty="0">
                          <a:effectLst/>
                        </a:rPr>
                      </a:br>
                      <a:r>
                        <a:rPr lang="en-US" sz="1200" kern="0" dirty="0">
                          <a:effectLst/>
                        </a:rPr>
                        <a:t>SMIPP-</a:t>
                      </a:r>
                      <a:r>
                        <a:rPr lang="en-US" sz="1200" kern="0" dirty="0" err="1">
                          <a:effectLst/>
                        </a:rPr>
                        <a:t>Cb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</a:rPr>
                        <a:t>KPM11771.1</a:t>
                      </a:r>
                      <a:endParaRPr lang="ja-JP" sz="12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extLst>
                  <a:ext uri="{0D108BD9-81ED-4DB2-BD59-A6C34878D82A}">
                    <a16:rowId xmlns:a16="http://schemas.microsoft.com/office/drawing/2014/main" val="2554075002"/>
                  </a:ext>
                </a:extLst>
              </a:tr>
              <a:tr h="32137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>
                          <a:effectLst/>
                        </a:rPr>
                        <a:t>1031</a:t>
                      </a:r>
                      <a:endParaRPr lang="ja-JP" sz="12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chemeClr val="tx1"/>
                          </a:solidFill>
                          <a:effectLst/>
                        </a:rPr>
                        <a:t>Sar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. S 1 cysteine protease–like protein 2</a:t>
                      </a:r>
                      <a:b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</a:b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(IACW01001925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AAS93667.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KPM05040.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extLst>
                  <a:ext uri="{0D108BD9-81ED-4DB2-BD59-A6C34878D82A}">
                    <a16:rowId xmlns:a16="http://schemas.microsoft.com/office/drawing/2014/main" val="2342712906"/>
                  </a:ext>
                </a:extLst>
              </a:tr>
              <a:tr h="32137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1352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chemeClr val="tx1"/>
                          </a:solidFill>
                          <a:effectLst/>
                        </a:rPr>
                        <a:t>Sar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. S 1 cysteine protease–like protein 8</a:t>
                      </a:r>
                      <a:b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</a:b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(IACW01021977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AAS93672.1</a:t>
                      </a:r>
                      <a:br>
                        <a:rPr lang="en-US" sz="1200" kern="0" dirty="0">
                          <a:effectLst/>
                        </a:rPr>
                      </a:br>
                      <a:r>
                        <a:rPr lang="en-US" sz="1200" kern="0" dirty="0">
                          <a:effectLst/>
                        </a:rPr>
                        <a:t>SMIPP-Ca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KPM05046.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extLst>
                  <a:ext uri="{0D108BD9-81ED-4DB2-BD59-A6C34878D82A}">
                    <a16:rowId xmlns:a16="http://schemas.microsoft.com/office/drawing/2014/main" val="647321084"/>
                  </a:ext>
                </a:extLst>
              </a:tr>
              <a:tr h="32137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1796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chemeClr val="tx1"/>
                          </a:solidFill>
                          <a:effectLst/>
                        </a:rPr>
                        <a:t>Sar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. S 1 cysteine protease–like protein 1</a:t>
                      </a:r>
                      <a:b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</a:b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(IACW01025763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AAS93668.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KPM05039.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extLst>
                  <a:ext uri="{0D108BD9-81ED-4DB2-BD59-A6C34878D82A}">
                    <a16:rowId xmlns:a16="http://schemas.microsoft.com/office/drawing/2014/main" val="3505212845"/>
                  </a:ext>
                </a:extLst>
              </a:tr>
              <a:tr h="32137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3238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chemeClr val="tx1"/>
                          </a:solidFill>
                          <a:effectLst/>
                        </a:rPr>
                        <a:t>Sar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. S 1 cysteine protease–like protein 5</a:t>
                      </a:r>
                      <a:b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</a:b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(IACW01025772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AAS93671.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KPM05043.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extLst>
                  <a:ext uri="{0D108BD9-81ED-4DB2-BD59-A6C34878D82A}">
                    <a16:rowId xmlns:a16="http://schemas.microsoft.com/office/drawing/2014/main" val="1154428301"/>
                  </a:ext>
                </a:extLst>
              </a:tr>
              <a:tr h="32137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4315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chemeClr val="tx1"/>
                          </a:solidFill>
                          <a:effectLst/>
                        </a:rPr>
                        <a:t>Sar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. S 1 cysteine protease–like protein 6</a:t>
                      </a:r>
                      <a:b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</a:b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(IACW01025774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-</a:t>
                      </a:r>
                      <a:br>
                        <a:rPr lang="en-US" sz="1200" kern="0" dirty="0">
                          <a:effectLst/>
                        </a:rPr>
                      </a:br>
                      <a:r>
                        <a:rPr lang="en-US" sz="1200" kern="0" dirty="0">
                          <a:effectLst/>
                        </a:rPr>
                        <a:t>SMIPP-</a:t>
                      </a:r>
                      <a:r>
                        <a:rPr lang="en-US" sz="1200" kern="0" dirty="0" err="1">
                          <a:effectLst/>
                        </a:rPr>
                        <a:t>Cf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KPM05044.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extLst>
                  <a:ext uri="{0D108BD9-81ED-4DB2-BD59-A6C34878D82A}">
                    <a16:rowId xmlns:a16="http://schemas.microsoft.com/office/drawing/2014/main" val="2635549615"/>
                  </a:ext>
                </a:extLst>
              </a:tr>
              <a:tr h="32137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5792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chemeClr val="tx1"/>
                          </a:solidFill>
                          <a:effectLst/>
                        </a:rPr>
                        <a:t>Sar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. S 1 cysteine protease–like protein 7</a:t>
                      </a:r>
                      <a:b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</a:b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</a:rPr>
                        <a:t>(IACW01021976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AAS93674.1</a:t>
                      </a:r>
                      <a:br>
                        <a:rPr lang="en-US" sz="1200" kern="0" dirty="0">
                          <a:effectLst/>
                        </a:rPr>
                      </a:br>
                      <a:r>
                        <a:rPr lang="en-US" sz="1200" kern="0" dirty="0">
                          <a:effectLst/>
                        </a:rPr>
                        <a:t>SMIPP-Ce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KPM05045.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extLst>
                  <a:ext uri="{0D108BD9-81ED-4DB2-BD59-A6C34878D82A}">
                    <a16:rowId xmlns:a16="http://schemas.microsoft.com/office/drawing/2014/main" val="999805253"/>
                  </a:ext>
                </a:extLst>
              </a:tr>
              <a:tr h="33476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Der p 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ja-JP" sz="1200" kern="0">
                          <a:effectLst/>
                        </a:rPr>
                        <a:t>　</a:t>
                      </a:r>
                      <a:endParaRPr lang="ja-JP" sz="12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AAB60215.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ja-JP" sz="1200" kern="0" dirty="0">
                          <a:effectLst/>
                        </a:rPr>
                        <a:t>　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extLst>
                  <a:ext uri="{0D108BD9-81ED-4DB2-BD59-A6C34878D82A}">
                    <a16:rowId xmlns:a16="http://schemas.microsoft.com/office/drawing/2014/main" val="156699921"/>
                  </a:ext>
                </a:extLst>
              </a:tr>
              <a:tr h="33476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Der f 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ja-JP" sz="1200" kern="0">
                          <a:effectLst/>
                        </a:rPr>
                        <a:t>　</a:t>
                      </a:r>
                      <a:endParaRPr lang="ja-JP" sz="120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</a:rPr>
                        <a:t>OTF70625.1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ja-JP" sz="1200" kern="0" dirty="0">
                          <a:effectLst/>
                        </a:rPr>
                        <a:t>　</a:t>
                      </a:r>
                      <a:endParaRPr lang="ja-JP" sz="12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5235" marR="55235" marT="0" marB="0" anchor="ctr"/>
                </a:tc>
                <a:extLst>
                  <a:ext uri="{0D108BD9-81ED-4DB2-BD59-A6C34878D82A}">
                    <a16:rowId xmlns:a16="http://schemas.microsoft.com/office/drawing/2014/main" val="2175151181"/>
                  </a:ext>
                </a:extLst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2063553" y="382796"/>
            <a:ext cx="8324715" cy="738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400" b="1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upplementary Table 3.</a:t>
            </a:r>
            <a:endParaRPr kumimoji="0" lang="en-US" altLang="ja-JP" sz="1400" dirty="0"/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AU" altLang="ja-JP" sz="1400" b="1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rotein accession numbers of </a:t>
            </a:r>
            <a:r>
              <a:rPr kumimoji="0" lang="en-AU" altLang="ja-JP" sz="1400" b="1" i="1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. </a:t>
            </a:r>
            <a:r>
              <a:rPr kumimoji="0" lang="en-AU" altLang="ja-JP" sz="1400" b="1" i="1" dirty="0" err="1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cabiei</a:t>
            </a:r>
            <a:r>
              <a:rPr kumimoji="0" lang="en-AU" altLang="ja-JP" sz="1400" b="1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 cysteine </a:t>
            </a:r>
            <a:r>
              <a:rPr kumimoji="0" lang="en-AU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rotease</a:t>
            </a:r>
            <a:r>
              <a:rPr kumimoji="0" lang="en-AU" altLang="ja-JP" sz="1400" b="1" dirty="0"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–</a:t>
            </a:r>
            <a:r>
              <a:rPr kumimoji="0" lang="en-AU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like </a:t>
            </a:r>
            <a:r>
              <a:rPr kumimoji="0" lang="en-AU" altLang="ja-JP" sz="1400" b="1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rotein and homologous HDM </a:t>
            </a:r>
            <a:endParaRPr kumimoji="0" lang="en-AU" altLang="ja-JP" sz="1400" dirty="0"/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en-AU" altLang="ja-JP" sz="14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06348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正方形/長方形 7"/>
          <p:cNvSpPr/>
          <p:nvPr/>
        </p:nvSpPr>
        <p:spPr>
          <a:xfrm flipH="1">
            <a:off x="2587102" y="710791"/>
            <a:ext cx="3341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/>
              <a:t>M          </a:t>
            </a:r>
            <a:r>
              <a:rPr lang="ja-JP" altLang="en-US" b="1" dirty="0"/>
              <a:t>　</a:t>
            </a:r>
            <a:r>
              <a:rPr lang="en-US" altLang="ja-JP" b="1" dirty="0"/>
              <a:t>                     </a:t>
            </a:r>
          </a:p>
        </p:txBody>
      </p:sp>
      <p:sp>
        <p:nvSpPr>
          <p:cNvPr id="9" name="正方形/長方形 8"/>
          <p:cNvSpPr/>
          <p:nvPr/>
        </p:nvSpPr>
        <p:spPr>
          <a:xfrm>
            <a:off x="2131727" y="2281954"/>
            <a:ext cx="39145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600" dirty="0"/>
              <a:t>1000-</a:t>
            </a:r>
            <a:endParaRPr lang="ja-JP" altLang="en-US" sz="600" dirty="0"/>
          </a:p>
        </p:txBody>
      </p:sp>
      <p:sp>
        <p:nvSpPr>
          <p:cNvPr id="10" name="正方形/長方形 9"/>
          <p:cNvSpPr/>
          <p:nvPr/>
        </p:nvSpPr>
        <p:spPr>
          <a:xfrm>
            <a:off x="2129772" y="1728513"/>
            <a:ext cx="39145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600" dirty="0"/>
              <a:t>4000-</a:t>
            </a:r>
            <a:endParaRPr lang="ja-JP" altLang="en-US" sz="600" dirty="0"/>
          </a:p>
        </p:txBody>
      </p:sp>
      <p:sp>
        <p:nvSpPr>
          <p:cNvPr id="11" name="正方形/長方形 10"/>
          <p:cNvSpPr/>
          <p:nvPr/>
        </p:nvSpPr>
        <p:spPr>
          <a:xfrm>
            <a:off x="2131727" y="2121366"/>
            <a:ext cx="39145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600" dirty="0"/>
              <a:t>1400-</a:t>
            </a:r>
            <a:endParaRPr lang="ja-JP" altLang="en-US" sz="600" dirty="0"/>
          </a:p>
        </p:txBody>
      </p:sp>
      <p:sp>
        <p:nvSpPr>
          <p:cNvPr id="12" name="正方形/長方形 11"/>
          <p:cNvSpPr/>
          <p:nvPr/>
        </p:nvSpPr>
        <p:spPr>
          <a:xfrm>
            <a:off x="2132916" y="1927890"/>
            <a:ext cx="39145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600" dirty="0"/>
              <a:t>2000-</a:t>
            </a:r>
            <a:endParaRPr lang="ja-JP" altLang="en-US" sz="600" dirty="0"/>
          </a:p>
        </p:txBody>
      </p:sp>
      <p:sp>
        <p:nvSpPr>
          <p:cNvPr id="13" name="正方形/長方形 12"/>
          <p:cNvSpPr/>
          <p:nvPr/>
        </p:nvSpPr>
        <p:spPr>
          <a:xfrm>
            <a:off x="2131727" y="1782992"/>
            <a:ext cx="39145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600" dirty="0"/>
              <a:t>3000-</a:t>
            </a:r>
            <a:endParaRPr lang="ja-JP" altLang="en-US" sz="600" dirty="0"/>
          </a:p>
        </p:txBody>
      </p:sp>
      <p:sp>
        <p:nvSpPr>
          <p:cNvPr id="14" name="正方形/長方形 13"/>
          <p:cNvSpPr/>
          <p:nvPr/>
        </p:nvSpPr>
        <p:spPr>
          <a:xfrm>
            <a:off x="2170199" y="2451319"/>
            <a:ext cx="34817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600" dirty="0"/>
              <a:t>750-</a:t>
            </a:r>
            <a:endParaRPr lang="ja-JP" altLang="en-US" sz="600" dirty="0"/>
          </a:p>
        </p:txBody>
      </p:sp>
      <p:sp>
        <p:nvSpPr>
          <p:cNvPr id="15" name="正方形/長方形 14"/>
          <p:cNvSpPr/>
          <p:nvPr/>
        </p:nvSpPr>
        <p:spPr>
          <a:xfrm>
            <a:off x="2170199" y="3105153"/>
            <a:ext cx="34817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600" dirty="0"/>
              <a:t>200-</a:t>
            </a:r>
            <a:endParaRPr lang="ja-JP" altLang="en-US" sz="600" dirty="0"/>
          </a:p>
        </p:txBody>
      </p:sp>
      <p:sp>
        <p:nvSpPr>
          <p:cNvPr id="16" name="正方形/長方形 15"/>
          <p:cNvSpPr/>
          <p:nvPr/>
        </p:nvSpPr>
        <p:spPr>
          <a:xfrm>
            <a:off x="2170199" y="3365090"/>
            <a:ext cx="34817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600" dirty="0"/>
              <a:t>100-</a:t>
            </a:r>
            <a:endParaRPr lang="ja-JP" altLang="en-US" sz="600" dirty="0"/>
          </a:p>
        </p:txBody>
      </p:sp>
      <p:sp>
        <p:nvSpPr>
          <p:cNvPr id="17" name="正方形/長方形 16"/>
          <p:cNvSpPr/>
          <p:nvPr/>
        </p:nvSpPr>
        <p:spPr>
          <a:xfrm>
            <a:off x="2208671" y="3511093"/>
            <a:ext cx="30489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600" dirty="0"/>
              <a:t>50-</a:t>
            </a:r>
            <a:endParaRPr lang="ja-JP" altLang="en-US" sz="600" dirty="0"/>
          </a:p>
        </p:txBody>
      </p:sp>
      <p:sp>
        <p:nvSpPr>
          <p:cNvPr id="18" name="正方形/長方形 17"/>
          <p:cNvSpPr/>
          <p:nvPr/>
        </p:nvSpPr>
        <p:spPr>
          <a:xfrm>
            <a:off x="2170199" y="2935474"/>
            <a:ext cx="34817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600" dirty="0"/>
              <a:t>300-</a:t>
            </a:r>
            <a:endParaRPr lang="ja-JP" altLang="en-US" sz="600" dirty="0"/>
          </a:p>
        </p:txBody>
      </p:sp>
      <p:sp>
        <p:nvSpPr>
          <p:cNvPr id="19" name="正方形/長方形 18"/>
          <p:cNvSpPr/>
          <p:nvPr/>
        </p:nvSpPr>
        <p:spPr>
          <a:xfrm>
            <a:off x="2170199" y="2819785"/>
            <a:ext cx="34817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600" dirty="0"/>
              <a:t>400-</a:t>
            </a:r>
            <a:endParaRPr lang="ja-JP" altLang="en-US" sz="600" dirty="0"/>
          </a:p>
        </p:txBody>
      </p:sp>
      <p:sp>
        <p:nvSpPr>
          <p:cNvPr id="20" name="正方形/長方形 19"/>
          <p:cNvSpPr/>
          <p:nvPr/>
        </p:nvSpPr>
        <p:spPr>
          <a:xfrm>
            <a:off x="2170199" y="2673958"/>
            <a:ext cx="34817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600" dirty="0"/>
              <a:t>500-</a:t>
            </a:r>
            <a:endParaRPr lang="ja-JP" altLang="en-US" sz="600" dirty="0"/>
          </a:p>
        </p:txBody>
      </p:sp>
      <p:sp>
        <p:nvSpPr>
          <p:cNvPr id="21" name="正方形/長方形 20"/>
          <p:cNvSpPr/>
          <p:nvPr/>
        </p:nvSpPr>
        <p:spPr>
          <a:xfrm>
            <a:off x="2131727" y="2056474"/>
            <a:ext cx="39145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600" dirty="0"/>
              <a:t>1550-</a:t>
            </a:r>
            <a:endParaRPr lang="ja-JP" altLang="en-US" sz="600" dirty="0"/>
          </a:p>
        </p:txBody>
      </p:sp>
      <p:sp>
        <p:nvSpPr>
          <p:cNvPr id="22" name="正方形/長方形 21"/>
          <p:cNvSpPr/>
          <p:nvPr/>
        </p:nvSpPr>
        <p:spPr>
          <a:xfrm>
            <a:off x="2131727" y="1678972"/>
            <a:ext cx="39145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600" dirty="0"/>
              <a:t>6000-</a:t>
            </a:r>
            <a:endParaRPr lang="ja-JP" altLang="en-US" sz="600" dirty="0"/>
          </a:p>
        </p:txBody>
      </p:sp>
      <p:sp>
        <p:nvSpPr>
          <p:cNvPr id="24" name="正方形/長方形 23"/>
          <p:cNvSpPr/>
          <p:nvPr/>
        </p:nvSpPr>
        <p:spPr>
          <a:xfrm>
            <a:off x="2093256" y="1619649"/>
            <a:ext cx="43473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600" dirty="0"/>
              <a:t>10000-</a:t>
            </a:r>
            <a:endParaRPr lang="ja-JP" altLang="en-US" sz="600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4000" contrast="5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420" t="18279" r="30451" b="26882"/>
          <a:stretch/>
        </p:blipFill>
        <p:spPr>
          <a:xfrm>
            <a:off x="2439064" y="1074549"/>
            <a:ext cx="1641816" cy="35630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0" name="正方形/長方形 29"/>
          <p:cNvSpPr/>
          <p:nvPr/>
        </p:nvSpPr>
        <p:spPr>
          <a:xfrm>
            <a:off x="1794176" y="455064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正方形/長方形 35"/>
          <p:cNvSpPr/>
          <p:nvPr/>
        </p:nvSpPr>
        <p:spPr>
          <a:xfrm>
            <a:off x="6673086" y="108886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/>
          <p:cNvSpPr/>
          <p:nvPr/>
        </p:nvSpPr>
        <p:spPr>
          <a:xfrm rot="18408284">
            <a:off x="3350031" y="678341"/>
            <a:ext cx="67839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/>
              <a:t> PCR</a:t>
            </a:r>
            <a:endParaRPr lang="en-US" altLang="ja-JP" sz="1600" dirty="0"/>
          </a:p>
        </p:txBody>
      </p:sp>
      <p:cxnSp>
        <p:nvCxnSpPr>
          <p:cNvPr id="5" name="直線矢印コネクタ 4"/>
          <p:cNvCxnSpPr/>
          <p:nvPr/>
        </p:nvCxnSpPr>
        <p:spPr>
          <a:xfrm flipH="1" flipV="1">
            <a:off x="4091850" y="2853149"/>
            <a:ext cx="700136" cy="543"/>
          </a:xfrm>
          <a:prstGeom prst="straightConnector1">
            <a:avLst/>
          </a:prstGeom>
          <a:ln w="57150" cmpd="sng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4"/>
          <a:srcRect l="381" t="18831" r="55922" b="21003"/>
          <a:stretch/>
        </p:blipFill>
        <p:spPr>
          <a:xfrm>
            <a:off x="7093615" y="476448"/>
            <a:ext cx="4756468" cy="409227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正方形/長方形 31"/>
          <p:cNvSpPr/>
          <p:nvPr/>
        </p:nvSpPr>
        <p:spPr>
          <a:xfrm>
            <a:off x="397677" y="4932482"/>
            <a:ext cx="11295930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kern="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upplemetary</a:t>
            </a:r>
            <a:r>
              <a:rPr lang="en-US" altLang="ja-JP" sz="1400" b="1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kumimoji="0" lang="en-US" altLang="ja-JP" sz="14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</a:t>
            </a:r>
            <a:r>
              <a:rPr lang="en-US" altLang="ja-JP" sz="1400" b="1" kern="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1 </a:t>
            </a:r>
            <a:endParaRPr lang="en-US" altLang="ja-JP" sz="1400" b="1" kern="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Evidence of expression of hypothetical protein QR98_0091190 using RT-PCR and sequence analysis</a:t>
            </a:r>
            <a:endParaRPr lang="ja-JP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 Images of 2% agarose gels containing RT-PCR products stained with Gel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Green</a:t>
            </a:r>
            <a:r>
              <a:rPr lang="en-US" altLang="ja-JP" sz="14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to demonstrate the expression of the gene expressing the hypothetical protein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QR98_0091190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 As a negative control, PCR was performed for DNA without added reverse transcriptase for cDNA synthesis. Lane M shows the migration of the DNA marker ladder.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equence data of cloned hypothetical protein QR98_0091190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he results obtained using the two different sequence analysis methods employing Illumina RNA-seq and Sanger sequencing of RT-PCR products were identical. The presence of the gene transcript was demonstrated.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正方形/長方形 30"/>
          <p:cNvSpPr/>
          <p:nvPr/>
        </p:nvSpPr>
        <p:spPr>
          <a:xfrm rot="18408284">
            <a:off x="2831806" y="541514"/>
            <a:ext cx="104547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/>
              <a:t> RT-PCR</a:t>
            </a:r>
            <a:endParaRPr lang="en-US" altLang="ja-JP" sz="1600" dirty="0"/>
          </a:p>
        </p:txBody>
      </p:sp>
      <p:sp>
        <p:nvSpPr>
          <p:cNvPr id="4" name="Rectangle 3"/>
          <p:cNvSpPr/>
          <p:nvPr/>
        </p:nvSpPr>
        <p:spPr>
          <a:xfrm>
            <a:off x="2990564" y="2763619"/>
            <a:ext cx="777592" cy="15549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4727184" y="2725712"/>
            <a:ext cx="5769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450 </a:t>
            </a:r>
            <a:r>
              <a:rPr lang="en-US" sz="1000" dirty="0" err="1" smtClean="0"/>
              <a:t>bp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9592661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1919536" y="1340769"/>
            <a:ext cx="8352928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1)EGEGEGEGQGGAGGKGKGKGKGHGEGEGEGEGEGQGGAGGKGKGKDGDDEDEEEGEGKGKDKDGDDEDEDVGEGKGKDKDGDDEDEEEGEGKRKGKDKDGDDEDEDVGEGKGKGKGKGKGKGEGEGEGEGEGGMGGKGKGRGKGKGVGEGEGEGEGEGEGGAGGRGKGRGKGKGMGEEGEGEGKDKDQDDEDENGKGKDKGHGKGKRKGNHSRCRCMSKSLHQKLQKSKHLSDAYSMWLQLEAFFKQFLSKFGHHHHFSKFLKWLQVFFHRFHVKLSDIAIDMDIDPTIATAIALEAKT</a:t>
            </a:r>
            <a:r>
              <a:rPr lang="en-US" altLang="ja-JP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KNYSIKNKRRRK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 (314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2089076" y="3025012"/>
            <a:ext cx="784887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kumimoji="0" lang="en-US" altLang="ja-JP" sz="14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mino acid sequence of the hypothetical protein QR98_0091190 (transcription ranking 1st) and selected sequence (position at 300-313 in 314aa) of the peptide synthesized for immunization.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64734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1389188" y="5249044"/>
            <a:ext cx="9936037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kumimoji="0" lang="en-US" altLang="ja-JP" sz="14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mino acid sequence of </a:t>
            </a:r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MIPP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Cc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gene expression ranked 104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IACW01021976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; Sar s 1 allergen SMIPP-C Yv5009F04 [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Sarcoptes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scabiei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AS93675.1 ] in GenBank, cysteine protease-like protein 9, QR98_0045000 in our RNA-seq data) and homologs of  </a:t>
            </a:r>
            <a:r>
              <a:rPr lang="ja-JP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Dermatophagoides farinae 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llergen 1</a:t>
            </a:r>
            <a:r>
              <a:rPr lang="ja-JP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OTF70625.1) and </a:t>
            </a:r>
            <a:r>
              <a:rPr lang="ja-JP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Dermatophagoides pteronyssinus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allergen1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AAB60215.1). The synthesized peptide (position at 4-17 in 347aa) for immunization is shown in a red colored frame.</a:t>
            </a: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29401" y="190424"/>
            <a:ext cx="6790088" cy="4824536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1829202" y="235165"/>
            <a:ext cx="13715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scabiei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829202" y="415965"/>
            <a:ext cx="1800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pteronyssinus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829202" y="596764"/>
            <a:ext cx="13715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farinae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829202" y="896828"/>
            <a:ext cx="13715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scabiei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829202" y="1077628"/>
            <a:ext cx="1800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pteronyssinus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829202" y="1258427"/>
            <a:ext cx="13715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farinae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825448" y="1598991"/>
            <a:ext cx="13715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scabiei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825448" y="1779791"/>
            <a:ext cx="1800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pteronyssinus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825448" y="1960590"/>
            <a:ext cx="13715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farinae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825448" y="2275484"/>
            <a:ext cx="13715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scabiei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825448" y="2456284"/>
            <a:ext cx="1800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pteronyssinus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825448" y="2637083"/>
            <a:ext cx="13715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farinae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825448" y="2955505"/>
            <a:ext cx="13715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scabiei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825448" y="3136305"/>
            <a:ext cx="1800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pteronyssinus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825448" y="3317104"/>
            <a:ext cx="13715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farinae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825448" y="3646523"/>
            <a:ext cx="13715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scabiei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825448" y="3827323"/>
            <a:ext cx="1800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pteronyssinus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825448" y="4008122"/>
            <a:ext cx="13715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farinae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825448" y="4343356"/>
            <a:ext cx="13715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scabiei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825448" y="4524156"/>
            <a:ext cx="1800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pteronyssinus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825448" y="4704955"/>
            <a:ext cx="13715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ja-JP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farinae</a:t>
            </a:r>
            <a:endParaRPr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正方形/長方形 2"/>
          <p:cNvSpPr/>
          <p:nvPr/>
        </p:nvSpPr>
        <p:spPr>
          <a:xfrm>
            <a:off x="5933657" y="259018"/>
            <a:ext cx="1296144" cy="180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582964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6632" y="114134"/>
            <a:ext cx="8838736" cy="5272894"/>
          </a:xfrm>
          <a:prstGeom prst="rect">
            <a:avLst/>
          </a:prstGeom>
        </p:spPr>
      </p:pic>
      <p:sp>
        <p:nvSpPr>
          <p:cNvPr id="10" name="正方形/長方形 9"/>
          <p:cNvSpPr/>
          <p:nvPr/>
        </p:nvSpPr>
        <p:spPr>
          <a:xfrm>
            <a:off x="2577012" y="4989470"/>
            <a:ext cx="1110296" cy="432048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1" name="正方形/長方形 10"/>
          <p:cNvSpPr/>
          <p:nvPr/>
        </p:nvSpPr>
        <p:spPr>
          <a:xfrm>
            <a:off x="9810146" y="4559580"/>
            <a:ext cx="412998" cy="432048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0" name="正方形/長方形 19"/>
          <p:cNvSpPr/>
          <p:nvPr/>
        </p:nvSpPr>
        <p:spPr>
          <a:xfrm>
            <a:off x="2810512" y="5398765"/>
            <a:ext cx="6607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b="1" dirty="0">
                <a:solidFill>
                  <a:srgbClr val="00B0F0"/>
                </a:solidFill>
              </a:rPr>
              <a:t>Epitope</a:t>
            </a:r>
            <a:endParaRPr lang="ja-JP" altLang="en-US" sz="1000" b="1" dirty="0">
              <a:solidFill>
                <a:srgbClr val="00B0F0"/>
              </a:solidFill>
            </a:endParaRPr>
          </a:p>
        </p:txBody>
      </p:sp>
      <p:sp>
        <p:nvSpPr>
          <p:cNvPr id="13" name="下矢印 12"/>
          <p:cNvSpPr/>
          <p:nvPr/>
        </p:nvSpPr>
        <p:spPr>
          <a:xfrm>
            <a:off x="7884029" y="1725647"/>
            <a:ext cx="72008" cy="72000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8" name="正方形/長方形 17"/>
          <p:cNvSpPr/>
          <p:nvPr/>
        </p:nvSpPr>
        <p:spPr>
          <a:xfrm>
            <a:off x="7869741" y="1649162"/>
            <a:ext cx="69442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ja-JP" sz="800" u="sng" dirty="0">
                <a:solidFill>
                  <a:srgbClr val="FF0000"/>
                </a:solidFill>
              </a:rPr>
              <a:t>（</a:t>
            </a:r>
            <a:r>
              <a:rPr lang="en-US" altLang="ja-JP" sz="800" u="sng" dirty="0">
                <a:solidFill>
                  <a:srgbClr val="FF0000"/>
                </a:solidFill>
              </a:rPr>
              <a:t>P706T</a:t>
            </a:r>
            <a:r>
              <a:rPr lang="ja-JP" altLang="ja-JP" sz="800" u="sng" dirty="0">
                <a:solidFill>
                  <a:srgbClr val="FF0000"/>
                </a:solidFill>
              </a:rPr>
              <a:t>）</a:t>
            </a:r>
            <a:endParaRPr lang="ja-JP" altLang="en-US" sz="800" dirty="0">
              <a:solidFill>
                <a:srgbClr val="FF0000"/>
              </a:solidFill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742950" y="5656723"/>
            <a:ext cx="10868025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kern="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upplemetary</a:t>
            </a:r>
            <a:r>
              <a:rPr lang="en-US" altLang="ja-JP" sz="1400" b="1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kumimoji="0" lang="en-US" altLang="ja-JP" sz="14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</a:t>
            </a:r>
            <a:r>
              <a:rPr lang="en-US" altLang="ja-JP" sz="1400" b="1" kern="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4 </a:t>
            </a:r>
            <a:r>
              <a:rPr lang="en-US" altLang="ja-JP" sz="1400" b="1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mino acid sequence (1938 aa) of vitellogenin-like protein of </a:t>
            </a:r>
            <a:r>
              <a:rPr lang="en-US" altLang="ja-JP" sz="1400" b="1" i="1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. </a:t>
            </a:r>
            <a:r>
              <a:rPr lang="en-US" altLang="ja-JP" sz="1400" b="1" i="1" kern="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cabiei</a:t>
            </a:r>
            <a:r>
              <a:rPr lang="en-US" altLang="ja-JP" sz="1400" b="1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var. </a:t>
            </a:r>
            <a:r>
              <a:rPr lang="en-US" altLang="ja-JP" sz="1400" b="1" i="1" kern="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nyctereutis</a:t>
            </a:r>
            <a:r>
              <a:rPr lang="en-US" altLang="ja-JP" sz="1400" b="1" i="1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.</a:t>
            </a:r>
            <a:r>
              <a:rPr lang="en-US" altLang="ja-JP" sz="1400" b="1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</a:p>
          <a:p>
            <a:r>
              <a:rPr lang="en-US" altLang="ja-JP" sz="1400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In raccoon dog mites, one amino acid mutation (P706T) was found in comparison with homologs of </a:t>
            </a:r>
            <a:r>
              <a:rPr lang="en-US" altLang="ja-JP" sz="1400" kern="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vitelllogenin</a:t>
            </a:r>
            <a:r>
              <a:rPr lang="en-US" altLang="ja-JP" sz="1400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like protein sequences of </a:t>
            </a:r>
            <a:r>
              <a:rPr lang="en-US" altLang="ja-JP" sz="1400" i="1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. </a:t>
            </a:r>
            <a:r>
              <a:rPr lang="en-US" altLang="ja-JP" sz="1400" i="1" kern="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cabiei</a:t>
            </a:r>
            <a:r>
              <a:rPr lang="en-US" altLang="ja-JP" sz="1400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var. </a:t>
            </a:r>
            <a:r>
              <a:rPr lang="en-US" altLang="ja-JP" sz="1400" i="1" kern="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anis</a:t>
            </a:r>
            <a:r>
              <a:rPr lang="en-US" altLang="ja-JP" sz="1400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(dog) and </a:t>
            </a:r>
            <a:r>
              <a:rPr lang="en-US" altLang="ja-JP" sz="1400" i="1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. </a:t>
            </a:r>
            <a:r>
              <a:rPr lang="en-US" altLang="ja-JP" sz="1400" i="1" kern="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cabiei</a:t>
            </a:r>
            <a:r>
              <a:rPr lang="en-US" altLang="ja-JP" sz="1400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var. </a:t>
            </a:r>
            <a:r>
              <a:rPr lang="en-US" altLang="ja-JP" sz="1400" i="1" kern="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horminis</a:t>
            </a:r>
            <a:r>
              <a:rPr lang="en-US" altLang="ja-JP" sz="1400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(human). </a:t>
            </a:r>
          </a:p>
          <a:p>
            <a:r>
              <a:rPr lang="en-US" altLang="ja-JP" sz="1400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he sequences of human and dog mites were a </a:t>
            </a:r>
            <a:r>
              <a:rPr lang="en-US" altLang="ja-JP" sz="1400" kern="0" dirty="0" err="1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erdect</a:t>
            </a:r>
            <a:r>
              <a:rPr lang="en-US" altLang="ja-JP" sz="1400" kern="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400" kern="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match. The synthesized peptide (position at 1794-1822 aa) for immunization is shown in a red colored frame.</a:t>
            </a:r>
            <a:endParaRPr lang="ja-JP" altLang="ja-JP" sz="1400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72290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テキスト ボックス 27"/>
          <p:cNvSpPr txBox="1"/>
          <p:nvPr/>
        </p:nvSpPr>
        <p:spPr>
          <a:xfrm>
            <a:off x="2404709" y="1164264"/>
            <a:ext cx="65131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449486" y="1549537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464726" y="1767690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2464726" y="2048965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0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2670797" y="2273455"/>
            <a:ext cx="45163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7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2716518" y="2726897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2716518" y="3116061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37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2716518" y="3681669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2716518" y="4041709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716518" y="4513757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3105500" y="897548"/>
            <a:ext cx="202830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M   S     P      S    P   S     P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線コネクタ 3"/>
          <p:cNvCxnSpPr/>
          <p:nvPr/>
        </p:nvCxnSpPr>
        <p:spPr>
          <a:xfrm>
            <a:off x="3422548" y="920996"/>
            <a:ext cx="360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/>
          <p:cNvCxnSpPr/>
          <p:nvPr/>
        </p:nvCxnSpPr>
        <p:spPr>
          <a:xfrm>
            <a:off x="3926604" y="918943"/>
            <a:ext cx="360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/>
          <p:cNvCxnSpPr/>
          <p:nvPr/>
        </p:nvCxnSpPr>
        <p:spPr>
          <a:xfrm>
            <a:off x="4436475" y="918943"/>
            <a:ext cx="360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/>
          <p:cNvSpPr txBox="1"/>
          <p:nvPr/>
        </p:nvSpPr>
        <p:spPr>
          <a:xfrm>
            <a:off x="3130539" y="665027"/>
            <a:ext cx="188430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Extraction  10 </a:t>
            </a:r>
            <a:r>
              <a:rPr lang="en-US" altLang="ja-JP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dil</a:t>
            </a:r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   100 </a:t>
            </a:r>
            <a:r>
              <a:rPr lang="en-US" altLang="ja-JP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dil</a:t>
            </a:r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3116393" y="244449"/>
            <a:ext cx="20174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10-20%SDS-PAGE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正方形/長方形 59"/>
          <p:cNvSpPr/>
          <p:nvPr/>
        </p:nvSpPr>
        <p:spPr>
          <a:xfrm>
            <a:off x="357656" y="5363521"/>
            <a:ext cx="1202054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kumimoji="0" lang="en-US" altLang="ja-JP" sz="14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ja-JP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lang="en-US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0"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Detection of the hypothetical protein QR98_0091190 in the insoluble fraction of scabies mites using western blot analysis </a:t>
            </a:r>
            <a:endParaRPr kumimoji="0" lang="en-US" altLang="ja-JP" sz="1400" b="1" dirty="0" smtClean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r>
              <a:rPr kumimoji="0" lang="en-US" altLang="ja-JP" sz="14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he </a:t>
            </a:r>
            <a:r>
              <a:rPr kumimoji="0" lang="en-US" altLang="ja-JP" sz="14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whole mite extracts of</a:t>
            </a:r>
            <a:r>
              <a:rPr kumimoji="0" lang="en-US" altLang="ja-JP" sz="1400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S. scabies</a:t>
            </a:r>
            <a:r>
              <a:rPr kumimoji="0" lang="en-US" altLang="ja-JP" sz="14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were centrifuged (10,000 ×</a:t>
            </a:r>
            <a:r>
              <a:rPr kumimoji="0" lang="en-US" altLang="ja-JP" sz="1400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</a:t>
            </a:r>
            <a:r>
              <a:rPr kumimoji="0" lang="en-US" altLang="ja-JP" sz="14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10 min, room temperature); the supernatant was collected and precipitated. Precipitated fractions were </a:t>
            </a:r>
            <a:r>
              <a:rPr kumimoji="0" lang="en-US" altLang="ja-JP" sz="140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resolubilized</a:t>
            </a:r>
            <a:r>
              <a:rPr kumimoji="0" lang="en-US" altLang="ja-JP" sz="14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in 10 %SDS solution. Each fraction was diluted 10-100 times using the physiological buffer </a:t>
            </a:r>
            <a:r>
              <a:rPr kumimoji="0" lang="en-US" altLang="ja-JP" sz="140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ris</a:t>
            </a:r>
            <a:r>
              <a:rPr kumimoji="0" lang="en-US" altLang="ja-JP" sz="14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Buffered saline (pH7.4), 0.05% Tween </a:t>
            </a:r>
            <a:r>
              <a:rPr kumimoji="0" lang="en-US" altLang="ja-JP" sz="14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20 and </a:t>
            </a:r>
            <a:r>
              <a:rPr kumimoji="0" lang="en-US" altLang="ja-JP" sz="14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run on an SDS-PAGE </a:t>
            </a:r>
            <a:r>
              <a:rPr kumimoji="0" lang="en-US" altLang="ja-JP" sz="14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el. Faint </a:t>
            </a:r>
            <a:r>
              <a:rPr kumimoji="0" lang="en-US" altLang="ja-JP" sz="14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bands were detected in insoluble fraction </a:t>
            </a:r>
            <a:r>
              <a:rPr kumimoji="0" lang="en-US" altLang="ja-JP" sz="14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using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endParaRPr lang="en-US" altLang="ja-JP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lorimetric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etection method using </a:t>
            </a:r>
            <a:r>
              <a:rPr kumimoji="0" lang="en-US" altLang="ja-JP" sz="14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he </a:t>
            </a:r>
            <a:r>
              <a:rPr kumimoji="0" lang="en-US" altLang="ja-JP" sz="14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nti-hypothetical protein QR98_0091190 rabbit polyclonal </a:t>
            </a:r>
            <a:r>
              <a:rPr kumimoji="0" lang="en-US" altLang="ja-JP" sz="14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ntibody and </a:t>
            </a:r>
            <a:r>
              <a:rPr lang="en-US" altLang="ja-JP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zWestBlue</a:t>
            </a:r>
            <a:endParaRPr kumimoji="0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1124" y="806874"/>
            <a:ext cx="2451620" cy="4556434"/>
          </a:xfrm>
          <a:prstGeom prst="rect">
            <a:avLst/>
          </a:prstGeom>
          <a:ln>
            <a:noFill/>
          </a:ln>
        </p:spPr>
      </p:pic>
      <p:pic>
        <p:nvPicPr>
          <p:cNvPr id="64" name="図 6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572" r="-1951"/>
          <a:stretch/>
        </p:blipFill>
        <p:spPr>
          <a:xfrm>
            <a:off x="3096000" y="1090075"/>
            <a:ext cx="2016000" cy="413137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" name="直線コネクタ 6"/>
          <p:cNvCxnSpPr/>
          <p:nvPr/>
        </p:nvCxnSpPr>
        <p:spPr>
          <a:xfrm>
            <a:off x="6338795" y="809138"/>
            <a:ext cx="19730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50"/>
          <p:cNvSpPr txBox="1"/>
          <p:nvPr/>
        </p:nvSpPr>
        <p:spPr>
          <a:xfrm>
            <a:off x="6322893" y="602892"/>
            <a:ext cx="202830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M   S   </a:t>
            </a:r>
            <a:r>
              <a:rPr lang="en-US" altLang="ja-JP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P  </a:t>
            </a:r>
            <a:r>
              <a:rPr lang="en-US" altLang="ja-JP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ja-JP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S    </a:t>
            </a:r>
            <a:r>
              <a:rPr lang="en-US" altLang="ja-JP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P    S     </a:t>
            </a:r>
            <a:r>
              <a:rPr lang="en-US" altLang="ja-JP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線コネクタ 53"/>
          <p:cNvCxnSpPr/>
          <p:nvPr/>
        </p:nvCxnSpPr>
        <p:spPr>
          <a:xfrm>
            <a:off x="6605747" y="641136"/>
            <a:ext cx="360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/>
          <p:cNvCxnSpPr/>
          <p:nvPr/>
        </p:nvCxnSpPr>
        <p:spPr>
          <a:xfrm>
            <a:off x="7109803" y="641136"/>
            <a:ext cx="360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/>
          <p:cNvCxnSpPr/>
          <p:nvPr/>
        </p:nvCxnSpPr>
        <p:spPr>
          <a:xfrm>
            <a:off x="7595309" y="641136"/>
            <a:ext cx="360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/>
          <p:cNvSpPr txBox="1"/>
          <p:nvPr/>
        </p:nvSpPr>
        <p:spPr>
          <a:xfrm>
            <a:off x="6228753" y="91594"/>
            <a:ext cx="21166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Western blotting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6272551" y="408223"/>
            <a:ext cx="188430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Extraction  10 </a:t>
            </a:r>
            <a:r>
              <a:rPr lang="en-US" altLang="ja-JP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dil</a:t>
            </a:r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   100 </a:t>
            </a:r>
            <a:r>
              <a:rPr lang="en-US" altLang="ja-JP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dil</a:t>
            </a:r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6197523" y="1148232"/>
            <a:ext cx="1877295" cy="3941015"/>
          </a:xfrm>
          <a:prstGeom prst="rect">
            <a:avLst/>
          </a:prstGeom>
          <a:noFill/>
          <a:ln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5429162" y="1468233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5429162" y="1756265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5429162" y="2044297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0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5650472" y="2309469"/>
            <a:ext cx="45163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7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5650473" y="2821487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5650473" y="3327189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37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5650473" y="3948343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650473" y="4308383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5650473" y="4665560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5417618" y="1074148"/>
            <a:ext cx="65131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右矢印 2"/>
          <p:cNvSpPr/>
          <p:nvPr/>
        </p:nvSpPr>
        <p:spPr>
          <a:xfrm flipH="1">
            <a:off x="8288513" y="2890089"/>
            <a:ext cx="216024" cy="26161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2716518" y="4882220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5650473" y="4882220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329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Picture 2" descr="C:\Users\t.akuta\Desktop\会社資料\dani 20190830_140712_Ch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182" t="20795" r="17692" b="16559"/>
          <a:stretch/>
        </p:blipFill>
        <p:spPr bwMode="auto">
          <a:xfrm>
            <a:off x="8532000" y="1902851"/>
            <a:ext cx="2160000" cy="4212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9" name="Picture 2" descr="C:\Users\t.akuta\Desktop\danlQR98 20191114_143307_Ch.tif"/>
          <p:cNvPicPr preferRelativeResize="0">
            <a:picLocks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971" t="11503" r="28641" b="10028"/>
          <a:stretch/>
        </p:blipFill>
        <p:spPr bwMode="auto">
          <a:xfrm>
            <a:off x="4284000" y="1728000"/>
            <a:ext cx="1656000" cy="4032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正方形/長方形 3"/>
          <p:cNvSpPr/>
          <p:nvPr/>
        </p:nvSpPr>
        <p:spPr>
          <a:xfrm>
            <a:off x="8256241" y="972950"/>
            <a:ext cx="181011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Vitellogenin</a:t>
            </a:r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-like protein </a:t>
            </a:r>
          </a:p>
        </p:txBody>
      </p:sp>
      <p:sp>
        <p:nvSpPr>
          <p:cNvPr id="5" name="正方形/長方形 4"/>
          <p:cNvSpPr/>
          <p:nvPr/>
        </p:nvSpPr>
        <p:spPr>
          <a:xfrm>
            <a:off x="4367808" y="882504"/>
            <a:ext cx="1547218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Hypothetical protein</a:t>
            </a:r>
          </a:p>
          <a:p>
            <a:pPr lvl="0"/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 QR98_0091190</a:t>
            </a:r>
            <a:endParaRPr lang="ja-JP" altLang="ja-JP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6659876" y="992524"/>
            <a:ext cx="85151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MIPP-Cc</a:t>
            </a:r>
            <a:endParaRPr lang="ja-JP" altLang="ja-JP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566141" y="1759545"/>
            <a:ext cx="65131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7902045" y="2165305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7902045" y="2354277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7902045" y="2586909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0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8123356" y="2752133"/>
            <a:ext cx="45163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7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8123357" y="3127697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8123357" y="3387154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37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8123357" y="3847777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8123357" y="4132838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8123357" y="4535090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8123357" y="4875913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647204" y="1723004"/>
            <a:ext cx="65131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730691" y="2150447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730691" y="2329894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730691" y="2514901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0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952002" y="2749395"/>
            <a:ext cx="45163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7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952003" y="3118032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952003" y="3401732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37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952003" y="3891574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952003" y="4138761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952003" y="4522271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952003" y="4826765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pic>
        <p:nvPicPr>
          <p:cNvPr id="29" name="Picture 3" descr="C:\Users\t.akuta\Desktop\QR98 SDS dani3010.tif"/>
          <p:cNvPicPr preferRelativeResize="0">
            <a:picLocks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701" t="-7974" r="-558" b="-1197"/>
          <a:stretch/>
        </p:blipFill>
        <p:spPr bwMode="auto">
          <a:xfrm>
            <a:off x="2268000" y="1542851"/>
            <a:ext cx="1440000" cy="4032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0" name="テキスト ボックス 29"/>
          <p:cNvSpPr txBox="1"/>
          <p:nvPr/>
        </p:nvSpPr>
        <p:spPr>
          <a:xfrm>
            <a:off x="3622305" y="2158826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622305" y="2366848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3622305" y="2599480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0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3843616" y="2764704"/>
            <a:ext cx="45163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7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843617" y="3172072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843617" y="3428300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37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3843618" y="3932490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3843617" y="4202559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843617" y="4547661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3843617" y="4911344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5840241" y="2102807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5840241" y="2291779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5840241" y="2524411"/>
            <a:ext cx="67294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0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6061552" y="2767657"/>
            <a:ext cx="45163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7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6061553" y="3207812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5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6061553" y="3554567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37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6071281" y="3991793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6090737" y="4386644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6090737" y="4639865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5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6090737" y="4880458"/>
            <a:ext cx="45163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0-</a:t>
            </a:r>
            <a:endParaRPr lang="ja-JP" altLang="en-US" sz="11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cxnSp>
        <p:nvCxnSpPr>
          <p:cNvPr id="50" name="直線矢印コネクタ 49"/>
          <p:cNvCxnSpPr/>
          <p:nvPr/>
        </p:nvCxnSpPr>
        <p:spPr>
          <a:xfrm>
            <a:off x="8074255" y="2567476"/>
            <a:ext cx="452002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矢印コネクタ 50"/>
          <p:cNvCxnSpPr/>
          <p:nvPr/>
        </p:nvCxnSpPr>
        <p:spPr>
          <a:xfrm>
            <a:off x="8066304" y="4440192"/>
            <a:ext cx="452002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矢印コネクタ 51"/>
          <p:cNvCxnSpPr/>
          <p:nvPr/>
        </p:nvCxnSpPr>
        <p:spPr>
          <a:xfrm>
            <a:off x="8077256" y="2983681"/>
            <a:ext cx="452002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テキスト ボックス 52"/>
          <p:cNvSpPr txBox="1"/>
          <p:nvPr/>
        </p:nvSpPr>
        <p:spPr>
          <a:xfrm>
            <a:off x="7908902" y="1831553"/>
            <a:ext cx="65131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5839010" y="1756834"/>
            <a:ext cx="65131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線コネクタ 54"/>
          <p:cNvCxnSpPr/>
          <p:nvPr/>
        </p:nvCxnSpPr>
        <p:spPr>
          <a:xfrm>
            <a:off x="4319366" y="751433"/>
            <a:ext cx="588228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正方形/長方形 55"/>
          <p:cNvSpPr/>
          <p:nvPr/>
        </p:nvSpPr>
        <p:spPr>
          <a:xfrm>
            <a:off x="6308887" y="327580"/>
            <a:ext cx="337082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Western blotting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正方形/長方形 56"/>
          <p:cNvSpPr/>
          <p:nvPr/>
        </p:nvSpPr>
        <p:spPr>
          <a:xfrm>
            <a:off x="2024155" y="349447"/>
            <a:ext cx="2295212" cy="348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10-20% SDS-PAGE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正方形/長方形 57"/>
          <p:cNvSpPr/>
          <p:nvPr/>
        </p:nvSpPr>
        <p:spPr>
          <a:xfrm>
            <a:off x="2332343" y="5503514"/>
            <a:ext cx="146073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1    2    3   4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正方形/長方形 58"/>
          <p:cNvSpPr/>
          <p:nvPr/>
        </p:nvSpPr>
        <p:spPr>
          <a:xfrm>
            <a:off x="4454475" y="5666274"/>
            <a:ext cx="146073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1    2    3   4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正方形/長方形 59"/>
          <p:cNvSpPr/>
          <p:nvPr/>
        </p:nvSpPr>
        <p:spPr>
          <a:xfrm>
            <a:off x="6546139" y="5351216"/>
            <a:ext cx="146073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1   2    3    4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正方形/長方形 60"/>
          <p:cNvSpPr/>
          <p:nvPr/>
        </p:nvSpPr>
        <p:spPr>
          <a:xfrm>
            <a:off x="8637803" y="6173248"/>
            <a:ext cx="146073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1   2     3    4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正方形/長方形 61"/>
          <p:cNvSpPr/>
          <p:nvPr/>
        </p:nvSpPr>
        <p:spPr>
          <a:xfrm>
            <a:off x="2432388" y="1617357"/>
            <a:ext cx="146073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M  </a:t>
            </a:r>
            <a:r>
              <a:rPr lang="en-US" altLang="ja-JP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s</a:t>
            </a:r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ja-JP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Df</a:t>
            </a:r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ja-JP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Dp</a:t>
            </a:r>
            <a:endParaRPr lang="ja-JP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正方形/長方形 62"/>
          <p:cNvSpPr/>
          <p:nvPr/>
        </p:nvSpPr>
        <p:spPr>
          <a:xfrm>
            <a:off x="4512081" y="1525897"/>
            <a:ext cx="146073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M  </a:t>
            </a:r>
            <a:r>
              <a:rPr lang="en-US" altLang="ja-JP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s</a:t>
            </a:r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ja-JP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Df</a:t>
            </a:r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ja-JP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Dp</a:t>
            </a:r>
            <a:endParaRPr lang="ja-JP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正方形/長方形 63"/>
          <p:cNvSpPr/>
          <p:nvPr/>
        </p:nvSpPr>
        <p:spPr>
          <a:xfrm>
            <a:off x="6551967" y="1558555"/>
            <a:ext cx="146073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M  </a:t>
            </a:r>
            <a:r>
              <a:rPr lang="en-US" altLang="ja-JP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s</a:t>
            </a:r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ja-JP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Df</a:t>
            </a:r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ja-JP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Dp</a:t>
            </a:r>
            <a:endParaRPr lang="ja-JP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正方形/長方形 64"/>
          <p:cNvSpPr/>
          <p:nvPr/>
        </p:nvSpPr>
        <p:spPr>
          <a:xfrm>
            <a:off x="8604283" y="1617357"/>
            <a:ext cx="146073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M  </a:t>
            </a:r>
            <a:r>
              <a:rPr lang="en-US" altLang="ja-JP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s</a:t>
            </a:r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ja-JP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Df</a:t>
            </a:r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ja-JP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Dp</a:t>
            </a:r>
            <a:endParaRPr lang="ja-JP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直線コネクタ 65"/>
          <p:cNvCxnSpPr/>
          <p:nvPr/>
        </p:nvCxnSpPr>
        <p:spPr>
          <a:xfrm>
            <a:off x="2950508" y="1663076"/>
            <a:ext cx="55937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正方形/長方形 66"/>
          <p:cNvSpPr/>
          <p:nvPr/>
        </p:nvSpPr>
        <p:spPr>
          <a:xfrm>
            <a:off x="2915999" y="1386366"/>
            <a:ext cx="62839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HDM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直線コネクタ 67"/>
          <p:cNvCxnSpPr/>
          <p:nvPr/>
        </p:nvCxnSpPr>
        <p:spPr>
          <a:xfrm>
            <a:off x="5081714" y="1537723"/>
            <a:ext cx="55937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/>
          <p:cNvCxnSpPr/>
          <p:nvPr/>
        </p:nvCxnSpPr>
        <p:spPr>
          <a:xfrm>
            <a:off x="7192806" y="1570381"/>
            <a:ext cx="55937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/>
          <p:cNvCxnSpPr/>
          <p:nvPr/>
        </p:nvCxnSpPr>
        <p:spPr>
          <a:xfrm>
            <a:off x="9120336" y="1642391"/>
            <a:ext cx="55937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正方形/長方形 70"/>
          <p:cNvSpPr/>
          <p:nvPr/>
        </p:nvSpPr>
        <p:spPr>
          <a:xfrm>
            <a:off x="5012696" y="1257725"/>
            <a:ext cx="62839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HDM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正方形/長方形 71"/>
          <p:cNvSpPr/>
          <p:nvPr/>
        </p:nvSpPr>
        <p:spPr>
          <a:xfrm>
            <a:off x="7158297" y="1269298"/>
            <a:ext cx="62839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HDM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正方形/長方形 72"/>
          <p:cNvSpPr/>
          <p:nvPr/>
        </p:nvSpPr>
        <p:spPr>
          <a:xfrm>
            <a:off x="9131761" y="1351096"/>
            <a:ext cx="62839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HDM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直線矢印コネクタ 73"/>
          <p:cNvCxnSpPr/>
          <p:nvPr/>
        </p:nvCxnSpPr>
        <p:spPr>
          <a:xfrm>
            <a:off x="3996922" y="3238032"/>
            <a:ext cx="21468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矢印コネクタ 74"/>
          <p:cNvCxnSpPr/>
          <p:nvPr/>
        </p:nvCxnSpPr>
        <p:spPr>
          <a:xfrm>
            <a:off x="3990294" y="4519522"/>
            <a:ext cx="21468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矢印コネクタ 75"/>
          <p:cNvCxnSpPr/>
          <p:nvPr/>
        </p:nvCxnSpPr>
        <p:spPr>
          <a:xfrm>
            <a:off x="3991623" y="4950216"/>
            <a:ext cx="21468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矢印コネクタ 76"/>
          <p:cNvCxnSpPr/>
          <p:nvPr/>
        </p:nvCxnSpPr>
        <p:spPr>
          <a:xfrm>
            <a:off x="6222087" y="3201256"/>
            <a:ext cx="21468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0" name="図 7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870" t="-2998" r="11944" b="-2071"/>
          <a:stretch/>
        </p:blipFill>
        <p:spPr>
          <a:xfrm>
            <a:off x="6480000" y="1794851"/>
            <a:ext cx="1188000" cy="36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81" name="直線矢印コネクタ 80"/>
          <p:cNvCxnSpPr/>
          <p:nvPr/>
        </p:nvCxnSpPr>
        <p:spPr>
          <a:xfrm>
            <a:off x="6246082" y="3553575"/>
            <a:ext cx="21468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正方形/長方形 82"/>
          <p:cNvSpPr/>
          <p:nvPr/>
        </p:nvSpPr>
        <p:spPr>
          <a:xfrm>
            <a:off x="2348586" y="1831553"/>
            <a:ext cx="1339013" cy="334140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正方形/長方形 83"/>
          <p:cNvSpPr/>
          <p:nvPr/>
        </p:nvSpPr>
        <p:spPr>
          <a:xfrm>
            <a:off x="4429320" y="1911756"/>
            <a:ext cx="1238042" cy="334709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正方形/長方形 84"/>
          <p:cNvSpPr/>
          <p:nvPr/>
        </p:nvSpPr>
        <p:spPr>
          <a:xfrm>
            <a:off x="6551966" y="1911756"/>
            <a:ext cx="1116034" cy="33306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正方形/長方形 85"/>
          <p:cNvSpPr/>
          <p:nvPr/>
        </p:nvSpPr>
        <p:spPr>
          <a:xfrm>
            <a:off x="8604283" y="1918067"/>
            <a:ext cx="1247288" cy="32819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正方形/長方形 86"/>
          <p:cNvSpPr/>
          <p:nvPr/>
        </p:nvSpPr>
        <p:spPr>
          <a:xfrm>
            <a:off x="362188" y="6095371"/>
            <a:ext cx="5107621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kumimoji="0" lang="en-US" altLang="ja-JP" sz="14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</a:t>
            </a:r>
            <a:r>
              <a:rPr kumimoji="0" lang="en-US" altLang="ja-JP" sz="1400" b="1" dirty="0" smtClean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6 </a:t>
            </a:r>
          </a:p>
          <a:p>
            <a:r>
              <a:rPr kumimoji="0" lang="ja-JP" altLang="en-US" sz="1400" b="1" dirty="0" smtClean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　</a:t>
            </a:r>
            <a:r>
              <a:rPr kumimoji="0" lang="en-US" altLang="ja-JP" sz="1400" b="1" dirty="0" smtClean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Whole</a:t>
            </a:r>
            <a:r>
              <a:rPr kumimoji="0" lang="ja-JP" altLang="en-US" sz="1400" b="1" dirty="0" smtClean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kumimoji="0" lang="en-US" altLang="ja-JP" sz="1400" b="1" dirty="0" smtClean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el</a:t>
            </a:r>
            <a:r>
              <a:rPr kumimoji="0" lang="ja-JP" altLang="en-US" sz="14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kumimoji="0" lang="en-US" altLang="ja-JP" sz="1400" b="1" dirty="0" smtClean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nd membranes for Figure 4</a:t>
            </a:r>
            <a:r>
              <a:rPr lang="ja-JP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lang="en-US" altLang="ja-JP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03810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C:\Users\t.akuta\Desktop\IMG_1769.jpg"/>
          <p:cNvPicPr preferRelativeResize="0">
            <a:picLocks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5600"/>
                    </a14:imgEffect>
                    <a14:imgEffect>
                      <a14:saturation sat="145000"/>
                    </a14:imgEffect>
                    <a14:imgEffect>
                      <a14:brightnessContrast bright="-5000" contrast="2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776" t="48702" r="38559" b="46167"/>
          <a:stretch/>
        </p:blipFill>
        <p:spPr bwMode="auto">
          <a:xfrm rot="5400000" flipH="1" flipV="1">
            <a:off x="6809880" y="1530000"/>
            <a:ext cx="1332000" cy="432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テキスト ボックス 4"/>
          <p:cNvSpPr txBox="1"/>
          <p:nvPr/>
        </p:nvSpPr>
        <p:spPr>
          <a:xfrm>
            <a:off x="7714703" y="707893"/>
            <a:ext cx="11788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 therapy</a:t>
            </a: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6909267" y="734536"/>
            <a:ext cx="11788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Normal</a:t>
            </a:r>
          </a:p>
        </p:txBody>
      </p:sp>
      <p:sp>
        <p:nvSpPr>
          <p:cNvPr id="7" name="正方形/長方形 6"/>
          <p:cNvSpPr/>
          <p:nvPr/>
        </p:nvSpPr>
        <p:spPr>
          <a:xfrm>
            <a:off x="8167284" y="2431362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.6</a:t>
            </a:r>
          </a:p>
        </p:txBody>
      </p:sp>
      <p:sp>
        <p:nvSpPr>
          <p:cNvPr id="8" name="正方形/長方形 7"/>
          <p:cNvSpPr/>
          <p:nvPr/>
        </p:nvSpPr>
        <p:spPr>
          <a:xfrm>
            <a:off x="7299769" y="2431362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.1</a:t>
            </a:r>
          </a:p>
        </p:txBody>
      </p:sp>
      <p:sp>
        <p:nvSpPr>
          <p:cNvPr id="11" name="正方形/長方形 10"/>
          <p:cNvSpPr/>
          <p:nvPr/>
        </p:nvSpPr>
        <p:spPr>
          <a:xfrm>
            <a:off x="484473" y="4212543"/>
            <a:ext cx="11882594" cy="22467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kumimoji="0" lang="en-US" altLang="ja-JP" sz="14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</a:t>
            </a:r>
            <a:r>
              <a:rPr kumimoji="0" lang="en-US" altLang="ja-JP" sz="1400" b="1" dirty="0" smtClean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7 </a:t>
            </a:r>
          </a:p>
          <a:p>
            <a:r>
              <a:rPr kumimoji="0" lang="ja-JP" altLang="en-US" sz="1400" b="1" dirty="0" smtClean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　</a:t>
            </a:r>
            <a:r>
              <a:rPr kumimoji="0" lang="en-US" altLang="ja-JP" sz="1400" b="1" dirty="0" smtClean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riginal raw data of Figure 6B</a:t>
            </a:r>
          </a:p>
          <a:p>
            <a:r>
              <a:rPr kumimoji="0" lang="en-US" altLang="ja-JP" sz="1400" b="1" dirty="0" smtClean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</a:t>
            </a:r>
            <a:r>
              <a:rPr lang="ja-JP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Immunochromatography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test of scabies’s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vitellogeni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like protein from skin scrapings of raccoon dogs. </a:t>
            </a:r>
            <a:endParaRPr lang="en-US" altLang="ja-JP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  A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otal of 100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μl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of lysate from skin or mites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as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ispensed onto the cassette and allowed to migrate. The whole mite extracts of the HDM </a:t>
            </a:r>
          </a:p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   D.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pteronyssinus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farinae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ave negative results.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esults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ere read by eye or using an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immunochromato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reader after 15 min.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 Positive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esult (scabies) was indicated by a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lear red band at Test-line,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using skin extracts from ten scabies-infected raccoon dogs. </a:t>
            </a:r>
            <a:endParaRPr lang="en-US" altLang="ja-JP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   These photos were taken with TCR-500 </a:t>
            </a:r>
            <a:r>
              <a:rPr lang="en-US" altLang="ja-JP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muno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reader under the same exposure time. 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endParaRPr kumimoji="0" lang="en-US" altLang="ja-JP" sz="1400" b="1" dirty="0" smtClean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r>
              <a:rPr kumimoji="0" lang="en-US" altLang="ja-JP" sz="1400" b="1" dirty="0" smtClean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</a:t>
            </a:r>
            <a:r>
              <a:rPr kumimoji="0" lang="ja-JP" altLang="en-US" sz="14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ne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ealthy skin (Normal) and one cured skin extract treated with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ivermecti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Therapy) gave negative results. </a:t>
            </a:r>
            <a:endParaRPr lang="en-US" altLang="ja-JP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  These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hotos were taken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ith Digital camera  at the same time. 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911716" y="2431361"/>
            <a:ext cx="6447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 err="1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mABS</a:t>
            </a:r>
            <a:endParaRPr lang="en-US" altLang="ja-JP" sz="1200" b="1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" name="右矢印 11"/>
          <p:cNvSpPr/>
          <p:nvPr/>
        </p:nvSpPr>
        <p:spPr>
          <a:xfrm>
            <a:off x="1606201" y="1381580"/>
            <a:ext cx="154559" cy="72008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3" name="右矢印 12"/>
          <p:cNvSpPr/>
          <p:nvPr/>
        </p:nvSpPr>
        <p:spPr>
          <a:xfrm>
            <a:off x="1616744" y="1855297"/>
            <a:ext cx="154559" cy="72008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206274" y="727553"/>
            <a:ext cx="82364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Scabies</a:t>
            </a:r>
          </a:p>
        </p:txBody>
      </p:sp>
      <p:pic>
        <p:nvPicPr>
          <p:cNvPr id="19" name="図 18"/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-1" r="7692" b="7501"/>
          <a:stretch/>
        </p:blipFill>
        <p:spPr>
          <a:xfrm>
            <a:off x="5109986" y="1054489"/>
            <a:ext cx="432000" cy="133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図 19"/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4176" r="7692" b="3324"/>
          <a:stretch/>
        </p:blipFill>
        <p:spPr>
          <a:xfrm>
            <a:off x="1789011" y="1054489"/>
            <a:ext cx="432000" cy="133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正方形/長方形 20"/>
          <p:cNvSpPr/>
          <p:nvPr/>
        </p:nvSpPr>
        <p:spPr>
          <a:xfrm flipH="1">
            <a:off x="1654188" y="2431362"/>
            <a:ext cx="7276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8.9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正方形/長方形 21"/>
          <p:cNvSpPr/>
          <p:nvPr/>
        </p:nvSpPr>
        <p:spPr>
          <a:xfrm>
            <a:off x="5098314" y="2431362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.9</a:t>
            </a: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4742080" y="745044"/>
            <a:ext cx="11788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B</a:t>
            </a:r>
            <a:r>
              <a:rPr lang="en-US" altLang="ja-JP" sz="1200" dirty="0" smtClean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uffer</a:t>
            </a:r>
            <a:endParaRPr lang="en-US" altLang="ja-JP" sz="1200" dirty="0">
              <a:latin typeface="Meiryo UI" panose="020B0604030504040204" pitchFamily="50" charset="-128"/>
              <a:ea typeface="Meiryo UI" panose="020B0604030504040204" pitchFamily="50" charset="-128"/>
              <a:cs typeface="Meiryo UI" panose="020B0604030504040204" pitchFamily="50" charset="-128"/>
            </a:endParaRPr>
          </a:p>
        </p:txBody>
      </p:sp>
      <p:sp>
        <p:nvSpPr>
          <p:cNvPr id="26" name="正方形/長方形 25"/>
          <p:cNvSpPr/>
          <p:nvPr/>
        </p:nvSpPr>
        <p:spPr>
          <a:xfrm>
            <a:off x="4503578" y="2431362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.6</a:t>
            </a:r>
          </a:p>
        </p:txBody>
      </p:sp>
      <p:sp>
        <p:nvSpPr>
          <p:cNvPr id="27" name="正方形/長方形 26"/>
          <p:cNvSpPr/>
          <p:nvPr/>
        </p:nvSpPr>
        <p:spPr>
          <a:xfrm>
            <a:off x="4462438" y="745044"/>
            <a:ext cx="46679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D. p</a:t>
            </a:r>
            <a:endParaRPr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/>
          <p:cNvSpPr/>
          <p:nvPr/>
        </p:nvSpPr>
        <p:spPr>
          <a:xfrm>
            <a:off x="3814366" y="745044"/>
            <a:ext cx="4251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D. f</a:t>
            </a:r>
            <a:endParaRPr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755837" y="498179"/>
            <a:ext cx="11788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HDM</a:t>
            </a:r>
          </a:p>
        </p:txBody>
      </p:sp>
      <p:pic>
        <p:nvPicPr>
          <p:cNvPr id="30" name="図 29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499" b="8144"/>
          <a:stretch/>
        </p:blipFill>
        <p:spPr>
          <a:xfrm rot="5400000">
            <a:off x="4003392" y="1504489"/>
            <a:ext cx="1332000" cy="43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図 30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6" t="-1" r="8009" b="-1"/>
          <a:stretch/>
        </p:blipFill>
        <p:spPr>
          <a:xfrm rot="5400000">
            <a:off x="3346799" y="1504489"/>
            <a:ext cx="1332000" cy="43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正方形/長方形 31"/>
          <p:cNvSpPr/>
          <p:nvPr/>
        </p:nvSpPr>
        <p:spPr>
          <a:xfrm>
            <a:off x="3801547" y="2431362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.7</a:t>
            </a:r>
          </a:p>
        </p:txBody>
      </p:sp>
      <p:cxnSp>
        <p:nvCxnSpPr>
          <p:cNvPr id="33" name="直線コネクタ 32"/>
          <p:cNvCxnSpPr/>
          <p:nvPr/>
        </p:nvCxnSpPr>
        <p:spPr>
          <a:xfrm>
            <a:off x="3829536" y="745888"/>
            <a:ext cx="986969" cy="56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4" name="図 33"/>
          <p:cNvPicPr preferRelativeResize="0"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62" r="6323" b="2758"/>
          <a:stretch/>
        </p:blipFill>
        <p:spPr>
          <a:xfrm>
            <a:off x="2395465" y="1043144"/>
            <a:ext cx="432000" cy="133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" name="正方形/長方形 34"/>
          <p:cNvSpPr/>
          <p:nvPr/>
        </p:nvSpPr>
        <p:spPr>
          <a:xfrm flipH="1">
            <a:off x="2237830" y="2431361"/>
            <a:ext cx="7276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9.1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図 35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000321" y="1059836"/>
            <a:ext cx="432000" cy="133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7" name="正方形/長方形 36"/>
          <p:cNvSpPr/>
          <p:nvPr/>
        </p:nvSpPr>
        <p:spPr>
          <a:xfrm flipH="1">
            <a:off x="2874137" y="2424468"/>
            <a:ext cx="7276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4.5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正方形/長方形 37"/>
          <p:cNvSpPr/>
          <p:nvPr/>
        </p:nvSpPr>
        <p:spPr>
          <a:xfrm>
            <a:off x="525091" y="1276152"/>
            <a:ext cx="114326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Control-line</a:t>
            </a:r>
          </a:p>
        </p:txBody>
      </p:sp>
      <p:sp>
        <p:nvSpPr>
          <p:cNvPr id="39" name="正方形/長方形 38"/>
          <p:cNvSpPr/>
          <p:nvPr/>
        </p:nvSpPr>
        <p:spPr>
          <a:xfrm>
            <a:off x="708570" y="1717725"/>
            <a:ext cx="88152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Test-line</a:t>
            </a:r>
          </a:p>
        </p:txBody>
      </p:sp>
      <p:sp>
        <p:nvSpPr>
          <p:cNvPr id="2" name="正方形/長方形 1"/>
          <p:cNvSpPr/>
          <p:nvPr/>
        </p:nvSpPr>
        <p:spPr>
          <a:xfrm>
            <a:off x="589822" y="131969"/>
            <a:ext cx="5822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ja-JP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</a:t>
            </a:r>
            <a:r>
              <a:rPr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lang="ja-JP" altLang="en-US" dirty="0"/>
          </a:p>
        </p:txBody>
      </p:sp>
      <p:sp>
        <p:nvSpPr>
          <p:cNvPr id="41" name="正方形/長方形 40"/>
          <p:cNvSpPr/>
          <p:nvPr/>
        </p:nvSpPr>
        <p:spPr>
          <a:xfrm>
            <a:off x="5934997" y="143478"/>
            <a:ext cx="5822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ja-JP" b="1" dirty="0" smtClean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</a:t>
            </a:r>
            <a:r>
              <a:rPr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lang="ja-JP" altLang="en-US" dirty="0"/>
          </a:p>
        </p:txBody>
      </p:sp>
      <p:sp>
        <p:nvSpPr>
          <p:cNvPr id="42" name="右矢印 41"/>
          <p:cNvSpPr/>
          <p:nvPr/>
        </p:nvSpPr>
        <p:spPr>
          <a:xfrm>
            <a:off x="7024437" y="1356831"/>
            <a:ext cx="154559" cy="72008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43" name="右矢印 42"/>
          <p:cNvSpPr/>
          <p:nvPr/>
        </p:nvSpPr>
        <p:spPr>
          <a:xfrm>
            <a:off x="7034980" y="1776118"/>
            <a:ext cx="154559" cy="72008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44" name="正方形/長方形 43"/>
          <p:cNvSpPr/>
          <p:nvPr/>
        </p:nvSpPr>
        <p:spPr>
          <a:xfrm>
            <a:off x="5943327" y="1251403"/>
            <a:ext cx="114326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Control-line</a:t>
            </a:r>
          </a:p>
        </p:txBody>
      </p:sp>
      <p:sp>
        <p:nvSpPr>
          <p:cNvPr id="45" name="正方形/長方形 44"/>
          <p:cNvSpPr/>
          <p:nvPr/>
        </p:nvSpPr>
        <p:spPr>
          <a:xfrm>
            <a:off x="6126806" y="1638546"/>
            <a:ext cx="88152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Test-line</a:t>
            </a:r>
          </a:p>
        </p:txBody>
      </p:sp>
      <p:sp>
        <p:nvSpPr>
          <p:cNvPr id="46" name="正方形/長方形 45"/>
          <p:cNvSpPr/>
          <p:nvPr/>
        </p:nvSpPr>
        <p:spPr>
          <a:xfrm>
            <a:off x="6341098" y="2431362"/>
            <a:ext cx="6447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 err="1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mABS</a:t>
            </a:r>
            <a:endParaRPr lang="en-US" altLang="ja-JP" sz="1200" b="1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pic>
        <p:nvPicPr>
          <p:cNvPr id="40" name="Picture 4" descr="C:\Users\t.akuta\Desktop\IMG_1769.jpg"/>
          <p:cNvPicPr preferRelativeResize="0">
            <a:picLocks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5600"/>
                    </a14:imgEffect>
                    <a14:imgEffect>
                      <a14:saturation sat="145000"/>
                    </a14:imgEffect>
                    <a14:imgEffect>
                      <a14:brightnessContrast bright="-5000" contrast="2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590" t="40525" r="15248" b="17186"/>
          <a:stretch/>
        </p:blipFill>
        <p:spPr bwMode="auto">
          <a:xfrm rot="5400000" flipH="1" flipV="1">
            <a:off x="8600197" y="1668892"/>
            <a:ext cx="2556000" cy="1188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正方形/長方形 2"/>
          <p:cNvSpPr/>
          <p:nvPr/>
        </p:nvSpPr>
        <p:spPr>
          <a:xfrm>
            <a:off x="9086955" y="3607040"/>
            <a:ext cx="15824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ja-JP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Whole</a:t>
            </a:r>
            <a:r>
              <a:rPr kumimoji="0" lang="ja-JP" altLang="en-US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kumimoji="0" lang="en-US" altLang="ja-JP" b="1" dirty="0" smtClean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hoto</a:t>
            </a:r>
            <a:endParaRPr lang="ja-JP" altLang="en-US" dirty="0"/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9586192" y="734078"/>
            <a:ext cx="11788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 therapy</a:t>
            </a: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8922968" y="740475"/>
            <a:ext cx="11788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Normal</a:t>
            </a:r>
          </a:p>
        </p:txBody>
      </p:sp>
      <p:pic>
        <p:nvPicPr>
          <p:cNvPr id="49" name="Picture 4" descr="C:\Users\t.akuta\Desktop\IMG_1769.jpg"/>
          <p:cNvPicPr preferRelativeResize="0">
            <a:picLocks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5600"/>
                    </a14:imgEffect>
                    <a14:imgEffect>
                      <a14:saturation sat="145000"/>
                    </a14:imgEffect>
                    <a14:imgEffect>
                      <a14:brightnessContrast bright="-5000" contrast="2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911" t="68450" r="38394" b="26111"/>
          <a:stretch/>
        </p:blipFill>
        <p:spPr bwMode="auto">
          <a:xfrm rot="5400000" flipH="1" flipV="1">
            <a:off x="7683150" y="1534546"/>
            <a:ext cx="1332000" cy="432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911956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/>
          <p:cNvSpPr/>
          <p:nvPr/>
        </p:nvSpPr>
        <p:spPr>
          <a:xfrm>
            <a:off x="2063551" y="0"/>
            <a:ext cx="9420877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400" b="1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Table 1</a:t>
            </a:r>
            <a:r>
              <a:rPr lang="en-US" altLang="ja-JP" sz="1400" b="1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 </a:t>
            </a:r>
            <a:r>
              <a:rPr lang="en-US" altLang="ja-JP" sz="1400" b="1" kern="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bundances</a:t>
            </a:r>
            <a:r>
              <a:rPr lang="en-US" altLang="ja-JP" sz="1400" b="1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 </a:t>
            </a:r>
            <a:r>
              <a:rPr lang="en-US" altLang="ja-JP" sz="1400" b="1" kern="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annotated genes in the </a:t>
            </a:r>
            <a:r>
              <a:rPr lang="en-US" altLang="ja-JP" sz="1400" b="1" i="1" kern="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. scabies </a:t>
            </a:r>
            <a:r>
              <a:rPr lang="en-US" altLang="ja-JP" sz="1400" b="1" kern="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ranscriptome</a:t>
            </a:r>
            <a:endParaRPr lang="ja-JP" altLang="ja-JP" sz="1400" b="1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r>
              <a:rPr lang="en-US" altLang="ja-JP" sz="14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 </a:t>
            </a:r>
            <a:endParaRPr lang="ja-JP" altLang="ja-JP" sz="1400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1292750" y="6627168"/>
            <a:ext cx="6096000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sz="900" b="1" kern="10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*</a:t>
            </a:r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rom Morgan</a:t>
            </a:r>
            <a:r>
              <a:rPr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S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t al. (</a:t>
            </a:r>
            <a:r>
              <a:rPr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2017</a:t>
            </a:r>
            <a:r>
              <a:rPr lang="en-US" altLang="ja-JP" sz="90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6619" y="435256"/>
            <a:ext cx="9493001" cy="62270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96662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7</TotalTime>
  <Words>1481</Words>
  <Application>Microsoft Office PowerPoint</Application>
  <PresentationFormat>ワイド画面</PresentationFormat>
  <Paragraphs>290</Paragraphs>
  <Slides>11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9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1</vt:i4>
      </vt:variant>
    </vt:vector>
  </HeadingPairs>
  <TitlesOfParts>
    <vt:vector size="21" baseType="lpstr">
      <vt:lpstr>Meiryo UI</vt:lpstr>
      <vt:lpstr>ＭＳ ゴシック</vt:lpstr>
      <vt:lpstr>ＭＳ 明朝</vt:lpstr>
      <vt:lpstr>游ゴシック</vt:lpstr>
      <vt:lpstr>游ゴシック Light</vt:lpstr>
      <vt:lpstr>游明朝</vt:lpstr>
      <vt:lpstr>Arial</vt:lpstr>
      <vt:lpstr>Century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芥 照夫</dc:creator>
  <cp:lastModifiedBy>芥 照夫</cp:lastModifiedBy>
  <cp:revision>62</cp:revision>
  <dcterms:created xsi:type="dcterms:W3CDTF">2020-08-17T13:36:01Z</dcterms:created>
  <dcterms:modified xsi:type="dcterms:W3CDTF">2021-01-19T23:05:39Z</dcterms:modified>
</cp:coreProperties>
</file>